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9"/>
  </p:notesMasterIdLst>
  <p:sldIdLst>
    <p:sldId id="272" r:id="rId2"/>
    <p:sldId id="322" r:id="rId3"/>
    <p:sldId id="323" r:id="rId4"/>
    <p:sldId id="324" r:id="rId5"/>
    <p:sldId id="325" r:id="rId6"/>
    <p:sldId id="326" r:id="rId7"/>
    <p:sldId id="328" r:id="rId8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cques Colinge" initials="JC" lastIdx="6" clrIdx="0">
    <p:extLst>
      <p:ext uri="{19B8F6BF-5375-455C-9EA6-DF929625EA0E}">
        <p15:presenceInfo xmlns:p15="http://schemas.microsoft.com/office/powerpoint/2012/main" userId="S-1-5-21-1023320073-945983482-3372322661-2228" providerId="AD"/>
      </p:ext>
    </p:extLst>
  </p:cmAuthor>
  <p:cmAuthor id="2" name="ekaterina.pisareva@ircm.local" initials="e" lastIdx="9" clrIdx="1">
    <p:extLst>
      <p:ext uri="{19B8F6BF-5375-455C-9EA6-DF929625EA0E}">
        <p15:presenceInfo xmlns:p15="http://schemas.microsoft.com/office/powerpoint/2012/main" userId="S-1-5-21-1023320073-945983482-3372322661-224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68B"/>
    <a:srgbClr val="CF179F"/>
    <a:srgbClr val="F129F0"/>
    <a:srgbClr val="3FE0D0"/>
    <a:srgbClr val="DEEBF7"/>
    <a:srgbClr val="FFA5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46" autoAdjust="0"/>
    <p:restoredTop sz="96237" autoAdjust="0"/>
  </p:normalViewPr>
  <p:slideViewPr>
    <p:cSldViewPr snapToGrid="0">
      <p:cViewPr varScale="1">
        <p:scale>
          <a:sx n="86" d="100"/>
          <a:sy n="86" d="100"/>
        </p:scale>
        <p:origin x="353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katerina.pisareva\Desktop\Ekaterina\End%20motifs%20050325\RGSO2\Calculs%20RGSO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DSP 5' vs DSP 3' </a:t>
            </a:r>
          </a:p>
          <a:p>
            <a:pPr>
              <a:defRPr/>
            </a:pPr>
            <a:r>
              <a:rPr lang="fr-FR"/>
              <a:t>(IRCM)</a:t>
            </a:r>
          </a:p>
        </c:rich>
      </c:tx>
      <c:layout>
        <c:manualLayout>
          <c:xMode val="edge"/>
          <c:yMode val="edge"/>
          <c:x val="0.10149814814814814"/>
          <c:y val="1.334424487452745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B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$4:$B$67</c:f>
              <c:numCache>
                <c:formatCode>General</c:formatCode>
                <c:ptCount val="64"/>
                <c:pt idx="0">
                  <c:v>6.3091303218318904E-4</c:v>
                </c:pt>
                <c:pt idx="1">
                  <c:v>7.7881864159148407E-4</c:v>
                </c:pt>
                <c:pt idx="2">
                  <c:v>8.7522470552389459E-4</c:v>
                </c:pt>
                <c:pt idx="3">
                  <c:v>2.5935839150228045E-3</c:v>
                </c:pt>
                <c:pt idx="4">
                  <c:v>3.8371033287111626E-3</c:v>
                </c:pt>
                <c:pt idx="5">
                  <c:v>3.9612676121174662E-3</c:v>
                </c:pt>
                <c:pt idx="6">
                  <c:v>4.1299685281432916E-3</c:v>
                </c:pt>
                <c:pt idx="7">
                  <c:v>4.7039646394623318E-3</c:v>
                </c:pt>
                <c:pt idx="8">
                  <c:v>4.763720763821107E-3</c:v>
                </c:pt>
                <c:pt idx="9">
                  <c:v>5.1722525419971343E-3</c:v>
                </c:pt>
                <c:pt idx="10">
                  <c:v>5.217010881765665E-3</c:v>
                </c:pt>
                <c:pt idx="11">
                  <c:v>5.6560129454721773E-3</c:v>
                </c:pt>
                <c:pt idx="12">
                  <c:v>6.1293837446120382E-3</c:v>
                </c:pt>
                <c:pt idx="13">
                  <c:v>6.5408106410617005E-3</c:v>
                </c:pt>
                <c:pt idx="14">
                  <c:v>6.5526963339496138E-3</c:v>
                </c:pt>
                <c:pt idx="15">
                  <c:v>8.0815908013414928E-3</c:v>
                </c:pt>
                <c:pt idx="16">
                  <c:v>8.145255324239464E-3</c:v>
                </c:pt>
                <c:pt idx="17">
                  <c:v>8.8109381511430138E-3</c:v>
                </c:pt>
                <c:pt idx="18">
                  <c:v>9.0443971567648173E-3</c:v>
                </c:pt>
                <c:pt idx="19">
                  <c:v>9.4866449145823168E-3</c:v>
                </c:pt>
                <c:pt idx="20">
                  <c:v>9.694234355162314E-3</c:v>
                </c:pt>
                <c:pt idx="21">
                  <c:v>9.7379039033551225E-3</c:v>
                </c:pt>
                <c:pt idx="22">
                  <c:v>1.0043539725223974E-2</c:v>
                </c:pt>
                <c:pt idx="23">
                  <c:v>1.0095948685333513E-2</c:v>
                </c:pt>
                <c:pt idx="24">
                  <c:v>1.0259853584458814E-2</c:v>
                </c:pt>
                <c:pt idx="25">
                  <c:v>1.0805581075623323E-2</c:v>
                </c:pt>
                <c:pt idx="26">
                  <c:v>1.0925194348876472E-2</c:v>
                </c:pt>
                <c:pt idx="27">
                  <c:v>1.2081023484442861E-2</c:v>
                </c:pt>
                <c:pt idx="28">
                  <c:v>1.2383657445317704E-2</c:v>
                </c:pt>
                <c:pt idx="29">
                  <c:v>1.2851397645333931E-2</c:v>
                </c:pt>
                <c:pt idx="30">
                  <c:v>1.384891452973676E-2</c:v>
                </c:pt>
                <c:pt idx="31">
                  <c:v>1.4307918872953409E-2</c:v>
                </c:pt>
                <c:pt idx="32">
                  <c:v>1.4757993539638423E-2</c:v>
                </c:pt>
                <c:pt idx="33">
                  <c:v>1.4781580595076409E-2</c:v>
                </c:pt>
                <c:pt idx="34">
                  <c:v>1.4958679266443332E-2</c:v>
                </c:pt>
                <c:pt idx="35">
                  <c:v>1.5035367322505509E-2</c:v>
                </c:pt>
                <c:pt idx="36">
                  <c:v>1.5284214869883401E-2</c:v>
                </c:pt>
                <c:pt idx="37">
                  <c:v>1.6801923445380222E-2</c:v>
                </c:pt>
                <c:pt idx="38">
                  <c:v>1.7076756630411239E-2</c:v>
                </c:pt>
                <c:pt idx="39">
                  <c:v>1.7980971673558659E-2</c:v>
                </c:pt>
                <c:pt idx="40">
                  <c:v>1.8597527936026315E-2</c:v>
                </c:pt>
                <c:pt idx="41">
                  <c:v>1.88223200985531E-2</c:v>
                </c:pt>
                <c:pt idx="42">
                  <c:v>1.8823149926371619E-2</c:v>
                </c:pt>
                <c:pt idx="43">
                  <c:v>1.9330366008621994E-2</c:v>
                </c:pt>
                <c:pt idx="44">
                  <c:v>1.9434037164263451E-2</c:v>
                </c:pt>
                <c:pt idx="45">
                  <c:v>1.9660843642204912E-2</c:v>
                </c:pt>
                <c:pt idx="46">
                  <c:v>1.985375806612627E-2</c:v>
                </c:pt>
                <c:pt idx="47">
                  <c:v>1.9859677110096421E-2</c:v>
                </c:pt>
                <c:pt idx="48">
                  <c:v>1.9940784815566468E-2</c:v>
                </c:pt>
                <c:pt idx="49">
                  <c:v>2.1252251095455726E-2</c:v>
                </c:pt>
                <c:pt idx="50">
                  <c:v>2.1882809068283632E-2</c:v>
                </c:pt>
                <c:pt idx="51">
                  <c:v>2.3469198008086684E-2</c:v>
                </c:pt>
                <c:pt idx="52">
                  <c:v>2.4096904197069113E-2</c:v>
                </c:pt>
                <c:pt idx="53">
                  <c:v>2.4964815804553484E-2</c:v>
                </c:pt>
                <c:pt idx="54">
                  <c:v>2.5040694035529311E-2</c:v>
                </c:pt>
                <c:pt idx="55">
                  <c:v>2.5416133298432668E-2</c:v>
                </c:pt>
                <c:pt idx="56">
                  <c:v>2.6183815127846666E-2</c:v>
                </c:pt>
                <c:pt idx="57">
                  <c:v>2.721541891033746E-2</c:v>
                </c:pt>
                <c:pt idx="58">
                  <c:v>2.9414110668972152E-2</c:v>
                </c:pt>
                <c:pt idx="59">
                  <c:v>3.0173134285523581E-2</c:v>
                </c:pt>
                <c:pt idx="60">
                  <c:v>3.0678131759599468E-2</c:v>
                </c:pt>
                <c:pt idx="61">
                  <c:v>4.5400222326509941E-2</c:v>
                </c:pt>
                <c:pt idx="62">
                  <c:v>5.0119590160583226E-2</c:v>
                </c:pt>
                <c:pt idx="63">
                  <c:v>5.15460928831647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80-4871-AA52-B34C7B5B852B}"/>
            </c:ext>
          </c:extLst>
        </c:ser>
        <c:ser>
          <c:idx val="1"/>
          <c:order val="1"/>
          <c:tx>
            <c:strRef>
              <c:f>'Freq HI DSP SSP'!$C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C$4:$C$67</c:f>
              <c:numCache>
                <c:formatCode>General</c:formatCode>
                <c:ptCount val="64"/>
                <c:pt idx="0">
                  <c:v>6.0485815867945564E-4</c:v>
                </c:pt>
                <c:pt idx="1">
                  <c:v>7.9090933564805841E-4</c:v>
                </c:pt>
                <c:pt idx="2">
                  <c:v>8.9097455205406945E-4</c:v>
                </c:pt>
                <c:pt idx="3">
                  <c:v>2.6114674419079596E-3</c:v>
                </c:pt>
                <c:pt idx="4">
                  <c:v>3.8545586990866854E-3</c:v>
                </c:pt>
                <c:pt idx="5">
                  <c:v>3.9809974688976299E-3</c:v>
                </c:pt>
                <c:pt idx="6">
                  <c:v>4.0662386952278829E-3</c:v>
                </c:pt>
                <c:pt idx="7">
                  <c:v>4.7133433557275152E-3</c:v>
                </c:pt>
                <c:pt idx="8">
                  <c:v>4.7839193449708958E-3</c:v>
                </c:pt>
                <c:pt idx="9">
                  <c:v>4.9339362498233086E-3</c:v>
                </c:pt>
                <c:pt idx="10">
                  <c:v>5.2760342946664195E-3</c:v>
                </c:pt>
                <c:pt idx="11">
                  <c:v>5.7515019120697166E-3</c:v>
                </c:pt>
                <c:pt idx="12">
                  <c:v>6.1762152550160453E-3</c:v>
                </c:pt>
                <c:pt idx="13">
                  <c:v>6.5794227203657659E-3</c:v>
                </c:pt>
                <c:pt idx="14">
                  <c:v>6.3413566200722559E-3</c:v>
                </c:pt>
                <c:pt idx="15">
                  <c:v>8.1354327962645853E-3</c:v>
                </c:pt>
                <c:pt idx="16">
                  <c:v>8.1845206074551251E-3</c:v>
                </c:pt>
                <c:pt idx="17">
                  <c:v>8.5609049373563343E-3</c:v>
                </c:pt>
                <c:pt idx="18">
                  <c:v>9.0647331716690403E-3</c:v>
                </c:pt>
                <c:pt idx="19">
                  <c:v>9.529214126390682E-3</c:v>
                </c:pt>
                <c:pt idx="20">
                  <c:v>9.7457839223382501E-3</c:v>
                </c:pt>
                <c:pt idx="21">
                  <c:v>9.8084986906881548E-3</c:v>
                </c:pt>
                <c:pt idx="22">
                  <c:v>1.0123434701736411E-2</c:v>
                </c:pt>
                <c:pt idx="23">
                  <c:v>1.0138151090775854E-2</c:v>
                </c:pt>
                <c:pt idx="24">
                  <c:v>1.0356790235279014E-2</c:v>
                </c:pt>
                <c:pt idx="25">
                  <c:v>1.0832566026507817E-2</c:v>
                </c:pt>
                <c:pt idx="26">
                  <c:v>1.105692937587921E-2</c:v>
                </c:pt>
                <c:pt idx="27">
                  <c:v>1.2156133181663718E-2</c:v>
                </c:pt>
                <c:pt idx="28">
                  <c:v>1.2365753813832677E-2</c:v>
                </c:pt>
                <c:pt idx="29">
                  <c:v>1.2454262715794704E-2</c:v>
                </c:pt>
                <c:pt idx="30">
                  <c:v>1.3922301097788959E-2</c:v>
                </c:pt>
                <c:pt idx="31">
                  <c:v>1.4219938924672725E-2</c:v>
                </c:pt>
                <c:pt idx="32">
                  <c:v>1.4664199103957807E-2</c:v>
                </c:pt>
                <c:pt idx="33">
                  <c:v>1.490048232926763E-2</c:v>
                </c:pt>
                <c:pt idx="34">
                  <c:v>1.5053868260319261E-2</c:v>
                </c:pt>
                <c:pt idx="35">
                  <c:v>1.46097450408183E-2</c:v>
                </c:pt>
                <c:pt idx="36">
                  <c:v>1.5193926342820779E-2</c:v>
                </c:pt>
                <c:pt idx="37">
                  <c:v>1.6918783447681388E-2</c:v>
                </c:pt>
                <c:pt idx="38">
                  <c:v>1.6875534941169335E-2</c:v>
                </c:pt>
                <c:pt idx="39">
                  <c:v>1.8052237719327329E-2</c:v>
                </c:pt>
                <c:pt idx="40">
                  <c:v>1.8476620289247514E-2</c:v>
                </c:pt>
                <c:pt idx="41">
                  <c:v>1.8626400850072708E-2</c:v>
                </c:pt>
                <c:pt idx="42">
                  <c:v>1.882896599090058E-2</c:v>
                </c:pt>
                <c:pt idx="43">
                  <c:v>1.9243569752283907E-2</c:v>
                </c:pt>
                <c:pt idx="44">
                  <c:v>1.9543761527920412E-2</c:v>
                </c:pt>
                <c:pt idx="45">
                  <c:v>1.989227182538637E-2</c:v>
                </c:pt>
                <c:pt idx="46">
                  <c:v>1.9981181594486641E-2</c:v>
                </c:pt>
                <c:pt idx="47">
                  <c:v>1.9975871677531939E-2</c:v>
                </c:pt>
                <c:pt idx="48">
                  <c:v>1.9982184014159462E-2</c:v>
                </c:pt>
                <c:pt idx="49">
                  <c:v>2.1378279426890835E-2</c:v>
                </c:pt>
                <c:pt idx="50">
                  <c:v>2.1782170966953035E-2</c:v>
                </c:pt>
                <c:pt idx="51">
                  <c:v>2.2905299166274515E-2</c:v>
                </c:pt>
                <c:pt idx="52">
                  <c:v>2.425829520353159E-2</c:v>
                </c:pt>
                <c:pt idx="53">
                  <c:v>2.5138755778379318E-2</c:v>
                </c:pt>
                <c:pt idx="54">
                  <c:v>2.5121396832962471E-2</c:v>
                </c:pt>
                <c:pt idx="55">
                  <c:v>2.5503114795515636E-2</c:v>
                </c:pt>
                <c:pt idx="56">
                  <c:v>2.6255633913392695E-2</c:v>
                </c:pt>
                <c:pt idx="57">
                  <c:v>2.7175581680104966E-2</c:v>
                </c:pt>
                <c:pt idx="58">
                  <c:v>2.9320995862483358E-2</c:v>
                </c:pt>
                <c:pt idx="59">
                  <c:v>3.0156065950988218E-2</c:v>
                </c:pt>
                <c:pt idx="60">
                  <c:v>3.0794977204961091E-2</c:v>
                </c:pt>
                <c:pt idx="61">
                  <c:v>4.5501616368423606E-2</c:v>
                </c:pt>
                <c:pt idx="62">
                  <c:v>5.0346838828075162E-2</c:v>
                </c:pt>
                <c:pt idx="63">
                  <c:v>5.15302897934051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80-4871-AA52-B34C7B5B85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6.0000000000000012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547561728395066"/>
          <c:y val="1.9376092208339479E-2"/>
          <c:w val="0.32693148211154444"/>
          <c:h val="2.20154048458873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b="0" dirty="0">
                <a:solidFill>
                  <a:schemeClr val="tx1"/>
                </a:solidFill>
              </a:rPr>
              <a:t>DSP</a:t>
            </a:r>
            <a:r>
              <a:rPr lang="fr-FR" b="0" baseline="0" dirty="0">
                <a:solidFill>
                  <a:schemeClr val="tx1"/>
                </a:solidFill>
              </a:rPr>
              <a:t> 5’ </a:t>
            </a:r>
          </a:p>
          <a:p>
            <a:pPr>
              <a:defRPr>
                <a:solidFill>
                  <a:schemeClr val="tx1"/>
                </a:solidFill>
              </a:defRPr>
            </a:pPr>
            <a:r>
              <a:rPr lang="fr-FR" b="0" baseline="0" dirty="0">
                <a:solidFill>
                  <a:schemeClr val="tx1"/>
                </a:solidFill>
              </a:rPr>
              <a:t>(IRCM)</a:t>
            </a:r>
            <a:endParaRPr lang="fr-FR" b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13446564655312387"/>
          <c:y val="4.9370221587993551E-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1042323732849454"/>
          <c:y val="5.1181771733339737E-2"/>
          <c:w val="0.80977648207290398"/>
          <c:h val="0.92361314078767254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Feuil1!$B$3</c:f>
              <c:strCache>
                <c:ptCount val="1"/>
                <c:pt idx="0">
                  <c:v>mCRC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Feuil1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Feuil1!$B$4:$B$67</c:f>
              <c:numCache>
                <c:formatCode>General</c:formatCode>
                <c:ptCount val="64"/>
                <c:pt idx="0">
                  <c:v>1.1256999043050672E-3</c:v>
                </c:pt>
                <c:pt idx="1">
                  <c:v>9.9542959805862209E-4</c:v>
                </c:pt>
                <c:pt idx="2">
                  <c:v>9.6007028509582915E-4</c:v>
                </c:pt>
                <c:pt idx="3">
                  <c:v>2.7493148784668089E-3</c:v>
                </c:pt>
                <c:pt idx="4">
                  <c:v>3.3945989205330517E-3</c:v>
                </c:pt>
                <c:pt idx="5">
                  <c:v>3.58318174112614E-3</c:v>
                </c:pt>
                <c:pt idx="6">
                  <c:v>5.5770329186657121E-3</c:v>
                </c:pt>
                <c:pt idx="7">
                  <c:v>4.1802546244154564E-3</c:v>
                </c:pt>
                <c:pt idx="8">
                  <c:v>5.2603846607363969E-3</c:v>
                </c:pt>
                <c:pt idx="9">
                  <c:v>8.9032254019188965E-3</c:v>
                </c:pt>
                <c:pt idx="10">
                  <c:v>6.9006205274980978E-3</c:v>
                </c:pt>
                <c:pt idx="11">
                  <c:v>4.6003942757685701E-3</c:v>
                </c:pt>
                <c:pt idx="12">
                  <c:v>7.1376917761548841E-3</c:v>
                </c:pt>
                <c:pt idx="13">
                  <c:v>7.172205056879712E-3</c:v>
                </c:pt>
                <c:pt idx="14">
                  <c:v>1.0259129286687227E-2</c:v>
                </c:pt>
                <c:pt idx="15">
                  <c:v>9.8622815739332331E-3</c:v>
                </c:pt>
                <c:pt idx="16">
                  <c:v>9.1919944313690223E-3</c:v>
                </c:pt>
                <c:pt idx="17">
                  <c:v>1.3619553333906092E-2</c:v>
                </c:pt>
                <c:pt idx="18">
                  <c:v>9.1480241929721342E-3</c:v>
                </c:pt>
                <c:pt idx="19">
                  <c:v>8.6207150550853227E-3</c:v>
                </c:pt>
                <c:pt idx="20">
                  <c:v>1.1146501351790964E-2</c:v>
                </c:pt>
                <c:pt idx="21">
                  <c:v>1.0157698713995873E-2</c:v>
                </c:pt>
                <c:pt idx="22">
                  <c:v>1.141040120907227E-2</c:v>
                </c:pt>
                <c:pt idx="23">
                  <c:v>9.8310126950799503E-3</c:v>
                </c:pt>
                <c:pt idx="24">
                  <c:v>1.0265295788024211E-2</c:v>
                </c:pt>
                <c:pt idx="25">
                  <c:v>1.058420859168881E-2</c:v>
                </c:pt>
                <c:pt idx="26">
                  <c:v>1.1620074159697064E-2</c:v>
                </c:pt>
                <c:pt idx="27">
                  <c:v>1.1800074067085919E-2</c:v>
                </c:pt>
                <c:pt idx="28">
                  <c:v>1.4311864004502141E-2</c:v>
                </c:pt>
                <c:pt idx="29">
                  <c:v>1.6246002019670365E-2</c:v>
                </c:pt>
                <c:pt idx="30">
                  <c:v>1.1597197058503131E-2</c:v>
                </c:pt>
                <c:pt idx="31">
                  <c:v>1.576392284130633E-2</c:v>
                </c:pt>
                <c:pt idx="32">
                  <c:v>1.7944035050930288E-2</c:v>
                </c:pt>
                <c:pt idx="33">
                  <c:v>1.2638645985096141E-2</c:v>
                </c:pt>
                <c:pt idx="34">
                  <c:v>1.2886224815185284E-2</c:v>
                </c:pt>
                <c:pt idx="35">
                  <c:v>1.626781690214979E-2</c:v>
                </c:pt>
                <c:pt idx="36">
                  <c:v>1.5979194547977374E-2</c:v>
                </c:pt>
                <c:pt idx="37">
                  <c:v>1.8190737488535835E-2</c:v>
                </c:pt>
                <c:pt idx="38">
                  <c:v>1.9209072504042819E-2</c:v>
                </c:pt>
                <c:pt idx="39">
                  <c:v>1.4987658269353301E-2</c:v>
                </c:pt>
                <c:pt idx="40">
                  <c:v>1.959285029447478E-2</c:v>
                </c:pt>
                <c:pt idx="41">
                  <c:v>2.1697126288823702E-2</c:v>
                </c:pt>
                <c:pt idx="42">
                  <c:v>1.6795664663149811E-2</c:v>
                </c:pt>
                <c:pt idx="43">
                  <c:v>2.2328799646573767E-2</c:v>
                </c:pt>
                <c:pt idx="44">
                  <c:v>1.5874073766366379E-2</c:v>
                </c:pt>
                <c:pt idx="45">
                  <c:v>2.0383680642539401E-2</c:v>
                </c:pt>
                <c:pt idx="46">
                  <c:v>1.6236613695790134E-2</c:v>
                </c:pt>
                <c:pt idx="47">
                  <c:v>1.6411763717905339E-2</c:v>
                </c:pt>
                <c:pt idx="48">
                  <c:v>1.9251519869822552E-2</c:v>
                </c:pt>
                <c:pt idx="49">
                  <c:v>1.6843846867180788E-2</c:v>
                </c:pt>
                <c:pt idx="50">
                  <c:v>2.3523904514467089E-2</c:v>
                </c:pt>
                <c:pt idx="51">
                  <c:v>2.5964960608284435E-2</c:v>
                </c:pt>
                <c:pt idx="52">
                  <c:v>2.4682696858417199E-2</c:v>
                </c:pt>
                <c:pt idx="53">
                  <c:v>2.1906918989053059E-2</c:v>
                </c:pt>
                <c:pt idx="54">
                  <c:v>2.4100931963105969E-2</c:v>
                </c:pt>
                <c:pt idx="55">
                  <c:v>2.8236153620380382E-2</c:v>
                </c:pt>
                <c:pt idx="56">
                  <c:v>2.7096312919638824E-2</c:v>
                </c:pt>
                <c:pt idx="57">
                  <c:v>3.1746992692008917E-2</c:v>
                </c:pt>
                <c:pt idx="58">
                  <c:v>3.2782953438999361E-2</c:v>
                </c:pt>
                <c:pt idx="59">
                  <c:v>3.0971616358383084E-2</c:v>
                </c:pt>
                <c:pt idx="60">
                  <c:v>3.041782136363921E-2</c:v>
                </c:pt>
                <c:pt idx="61">
                  <c:v>3.5331354065567776E-2</c:v>
                </c:pt>
                <c:pt idx="62">
                  <c:v>3.9637972283234749E-2</c:v>
                </c:pt>
                <c:pt idx="63">
                  <c:v>4.2104030364929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4C-464C-AEE6-74D09B04501C}"/>
            </c:ext>
          </c:extLst>
        </c:ser>
        <c:ser>
          <c:idx val="1"/>
          <c:order val="1"/>
          <c:tx>
            <c:strRef>
              <c:f>Feuil1!$C$3</c:f>
              <c:strCache>
                <c:ptCount val="1"/>
                <c:pt idx="0">
                  <c:v>NSCLC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Feuil1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Feuil1!$C$4:$C$67</c:f>
              <c:numCache>
                <c:formatCode>General</c:formatCode>
                <c:ptCount val="64"/>
                <c:pt idx="0">
                  <c:v>5.2412512586779282E-4</c:v>
                </c:pt>
                <c:pt idx="1">
                  <c:v>7.3723451265978281E-4</c:v>
                </c:pt>
                <c:pt idx="2">
                  <c:v>5.7631782271602629E-4</c:v>
                </c:pt>
                <c:pt idx="3">
                  <c:v>2.3617584044467121E-3</c:v>
                </c:pt>
                <c:pt idx="4">
                  <c:v>3.3143272295148673E-3</c:v>
                </c:pt>
                <c:pt idx="5">
                  <c:v>3.224789698778333E-3</c:v>
                </c:pt>
                <c:pt idx="6">
                  <c:v>5.4547814225718739E-3</c:v>
                </c:pt>
                <c:pt idx="7">
                  <c:v>4.8041493213320961E-3</c:v>
                </c:pt>
                <c:pt idx="8">
                  <c:v>4.943394489104273E-3</c:v>
                </c:pt>
                <c:pt idx="9">
                  <c:v>5.9941215137352174E-3</c:v>
                </c:pt>
                <c:pt idx="10">
                  <c:v>6.3204044241730135E-3</c:v>
                </c:pt>
                <c:pt idx="11">
                  <c:v>5.679467379587055E-3</c:v>
                </c:pt>
                <c:pt idx="12">
                  <c:v>5.689496134555481E-3</c:v>
                </c:pt>
                <c:pt idx="13">
                  <c:v>7.2359179323360735E-3</c:v>
                </c:pt>
                <c:pt idx="14">
                  <c:v>5.9117451641760603E-3</c:v>
                </c:pt>
                <c:pt idx="15">
                  <c:v>1.0933781043014004E-2</c:v>
                </c:pt>
                <c:pt idx="16">
                  <c:v>1.0455464575489527E-2</c:v>
                </c:pt>
                <c:pt idx="17">
                  <c:v>9.7381844787710198E-3</c:v>
                </c:pt>
                <c:pt idx="18">
                  <c:v>9.6446232277788025E-3</c:v>
                </c:pt>
                <c:pt idx="19">
                  <c:v>7.9929840620465691E-3</c:v>
                </c:pt>
                <c:pt idx="20">
                  <c:v>9.7631150736338605E-3</c:v>
                </c:pt>
                <c:pt idx="21">
                  <c:v>7.3308535362609801E-3</c:v>
                </c:pt>
                <c:pt idx="22">
                  <c:v>9.923991508204685E-3</c:v>
                </c:pt>
                <c:pt idx="23">
                  <c:v>9.7963241352371812E-3</c:v>
                </c:pt>
                <c:pt idx="24">
                  <c:v>1.0702873464699376E-2</c:v>
                </c:pt>
                <c:pt idx="25">
                  <c:v>9.6114062555640624E-3</c:v>
                </c:pt>
                <c:pt idx="26">
                  <c:v>1.1906505556649027E-2</c:v>
                </c:pt>
                <c:pt idx="27">
                  <c:v>1.2761337837412031E-2</c:v>
                </c:pt>
                <c:pt idx="28">
                  <c:v>1.035042412163242E-2</c:v>
                </c:pt>
                <c:pt idx="29">
                  <c:v>1.6057817384848412E-2</c:v>
                </c:pt>
                <c:pt idx="30">
                  <c:v>1.3603324270462304E-2</c:v>
                </c:pt>
                <c:pt idx="31">
                  <c:v>1.8395602542859969E-2</c:v>
                </c:pt>
                <c:pt idx="32">
                  <c:v>1.5910893723380899E-2</c:v>
                </c:pt>
                <c:pt idx="33">
                  <c:v>1.1193094263225475E-2</c:v>
                </c:pt>
                <c:pt idx="34">
                  <c:v>1.4400546545669701E-2</c:v>
                </c:pt>
                <c:pt idx="35">
                  <c:v>1.4402140833540857E-2</c:v>
                </c:pt>
                <c:pt idx="36">
                  <c:v>1.4618498789792102E-2</c:v>
                </c:pt>
                <c:pt idx="37">
                  <c:v>1.8549702696819378E-2</c:v>
                </c:pt>
                <c:pt idx="38">
                  <c:v>1.5806316658970955E-2</c:v>
                </c:pt>
                <c:pt idx="39">
                  <c:v>1.3223703776790849E-2</c:v>
                </c:pt>
                <c:pt idx="40">
                  <c:v>1.6139933720694086E-2</c:v>
                </c:pt>
                <c:pt idx="41">
                  <c:v>2.1937274793500165E-2</c:v>
                </c:pt>
                <c:pt idx="42">
                  <c:v>1.898592021314139E-2</c:v>
                </c:pt>
                <c:pt idx="43">
                  <c:v>1.6364265347006909E-2</c:v>
                </c:pt>
                <c:pt idx="44">
                  <c:v>1.418343061120555E-2</c:v>
                </c:pt>
                <c:pt idx="45">
                  <c:v>1.8523052771922538E-2</c:v>
                </c:pt>
                <c:pt idx="46">
                  <c:v>1.394392889821972E-2</c:v>
                </c:pt>
                <c:pt idx="47">
                  <c:v>1.6502258163768251E-2</c:v>
                </c:pt>
                <c:pt idx="48">
                  <c:v>2.1421015024723412E-2</c:v>
                </c:pt>
                <c:pt idx="49">
                  <c:v>1.5382946425398027E-2</c:v>
                </c:pt>
                <c:pt idx="50">
                  <c:v>2.7626894442400258E-2</c:v>
                </c:pt>
                <c:pt idx="51">
                  <c:v>2.2233638387048733E-2</c:v>
                </c:pt>
                <c:pt idx="52">
                  <c:v>2.3608187826992189E-2</c:v>
                </c:pt>
                <c:pt idx="53">
                  <c:v>2.1719008527109254E-2</c:v>
                </c:pt>
                <c:pt idx="54">
                  <c:v>2.8928271921191025E-2</c:v>
                </c:pt>
                <c:pt idx="55">
                  <c:v>2.7837764431322125E-2</c:v>
                </c:pt>
                <c:pt idx="56">
                  <c:v>2.7329914165016338E-2</c:v>
                </c:pt>
                <c:pt idx="57">
                  <c:v>2.7763427658719413E-2</c:v>
                </c:pt>
                <c:pt idx="58">
                  <c:v>2.9836187237670838E-2</c:v>
                </c:pt>
                <c:pt idx="59">
                  <c:v>3.5191772278718982E-2</c:v>
                </c:pt>
                <c:pt idx="60">
                  <c:v>2.8986414249479203E-2</c:v>
                </c:pt>
                <c:pt idx="61">
                  <c:v>4.7419009533959645E-2</c:v>
                </c:pt>
                <c:pt idx="62">
                  <c:v>5.1914742436994489E-2</c:v>
                </c:pt>
                <c:pt idx="63">
                  <c:v>5.637519999548834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4C-464C-AEE6-74D09B04501C}"/>
            </c:ext>
          </c:extLst>
        </c:ser>
        <c:ser>
          <c:idx val="2"/>
          <c:order val="2"/>
          <c:tx>
            <c:strRef>
              <c:f>Feuil1!$D$3</c:f>
              <c:strCache>
                <c:ptCount val="1"/>
                <c:pt idx="0">
                  <c:v>BC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Feuil1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Feuil1!$D$4:$D$67</c:f>
              <c:numCache>
                <c:formatCode>General</c:formatCode>
                <c:ptCount val="64"/>
                <c:pt idx="0">
                  <c:v>5.6921271908003134E-4</c:v>
                </c:pt>
                <c:pt idx="1">
                  <c:v>7.8985870282008441E-4</c:v>
                </c:pt>
                <c:pt idx="2">
                  <c:v>7.0079998654311163E-4</c:v>
                </c:pt>
                <c:pt idx="3">
                  <c:v>2.8035062678605487E-3</c:v>
                </c:pt>
                <c:pt idx="4">
                  <c:v>3.7164831309052897E-3</c:v>
                </c:pt>
                <c:pt idx="5">
                  <c:v>3.8646184809225811E-3</c:v>
                </c:pt>
                <c:pt idx="6">
                  <c:v>5.0624456391384597E-3</c:v>
                </c:pt>
                <c:pt idx="7">
                  <c:v>4.963114241427675E-3</c:v>
                </c:pt>
                <c:pt idx="8">
                  <c:v>4.9057820426887779E-3</c:v>
                </c:pt>
                <c:pt idx="9">
                  <c:v>6.0070218279897258E-3</c:v>
                </c:pt>
                <c:pt idx="10">
                  <c:v>6.0247790248780918E-3</c:v>
                </c:pt>
                <c:pt idx="11">
                  <c:v>5.8140094068237858E-3</c:v>
                </c:pt>
                <c:pt idx="12">
                  <c:v>5.9647987144183442E-3</c:v>
                </c:pt>
                <c:pt idx="13">
                  <c:v>7.116036194125098E-3</c:v>
                </c:pt>
                <c:pt idx="14">
                  <c:v>6.4047529597015982E-3</c:v>
                </c:pt>
                <c:pt idx="15">
                  <c:v>9.9944717031020709E-3</c:v>
                </c:pt>
                <c:pt idx="16">
                  <c:v>9.5959427459576113E-3</c:v>
                </c:pt>
                <c:pt idx="17">
                  <c:v>1.0103972033586697E-2</c:v>
                </c:pt>
                <c:pt idx="18">
                  <c:v>9.2007748182807367E-3</c:v>
                </c:pt>
                <c:pt idx="19">
                  <c:v>8.2215759042276945E-3</c:v>
                </c:pt>
                <c:pt idx="20">
                  <c:v>9.6394749319004772E-3</c:v>
                </c:pt>
                <c:pt idx="21">
                  <c:v>7.8961625720407897E-3</c:v>
                </c:pt>
                <c:pt idx="22">
                  <c:v>1.0369676773884499E-2</c:v>
                </c:pt>
                <c:pt idx="23">
                  <c:v>9.9805745200152538E-3</c:v>
                </c:pt>
                <c:pt idx="24">
                  <c:v>1.0501249238989221E-2</c:v>
                </c:pt>
                <c:pt idx="25">
                  <c:v>9.6756328226094684E-3</c:v>
                </c:pt>
                <c:pt idx="26">
                  <c:v>1.1233168891440026E-2</c:v>
                </c:pt>
                <c:pt idx="27">
                  <c:v>1.2490225832687859E-2</c:v>
                </c:pt>
                <c:pt idx="28">
                  <c:v>1.0745636453597336E-2</c:v>
                </c:pt>
                <c:pt idx="29">
                  <c:v>1.5563851689765098E-2</c:v>
                </c:pt>
                <c:pt idx="30">
                  <c:v>1.340268960578677E-2</c:v>
                </c:pt>
                <c:pt idx="31">
                  <c:v>1.7292497291923416E-2</c:v>
                </c:pt>
                <c:pt idx="32">
                  <c:v>1.6054849368502929E-2</c:v>
                </c:pt>
                <c:pt idx="33">
                  <c:v>1.2590872641630049E-2</c:v>
                </c:pt>
                <c:pt idx="34">
                  <c:v>1.3943616759347006E-2</c:v>
                </c:pt>
                <c:pt idx="35">
                  <c:v>1.4466136566695603E-2</c:v>
                </c:pt>
                <c:pt idx="36">
                  <c:v>1.4419385715055334E-2</c:v>
                </c:pt>
                <c:pt idx="37">
                  <c:v>1.8317941391574877E-2</c:v>
                </c:pt>
                <c:pt idx="38">
                  <c:v>1.5894860711988357E-2</c:v>
                </c:pt>
                <c:pt idx="39">
                  <c:v>1.390841066484586E-2</c:v>
                </c:pt>
                <c:pt idx="40">
                  <c:v>1.7004857223410594E-2</c:v>
                </c:pt>
                <c:pt idx="41">
                  <c:v>2.2225521961135381E-2</c:v>
                </c:pt>
                <c:pt idx="42">
                  <c:v>1.853151469668831E-2</c:v>
                </c:pt>
                <c:pt idx="43">
                  <c:v>1.7911217018741182E-2</c:v>
                </c:pt>
                <c:pt idx="44">
                  <c:v>1.5852450716277805E-2</c:v>
                </c:pt>
                <c:pt idx="45">
                  <c:v>1.86965194878972E-2</c:v>
                </c:pt>
                <c:pt idx="46">
                  <c:v>1.4723197518947028E-2</c:v>
                </c:pt>
                <c:pt idx="47">
                  <c:v>1.7289094378540613E-2</c:v>
                </c:pt>
                <c:pt idx="48">
                  <c:v>2.1078980026893679E-2</c:v>
                </c:pt>
                <c:pt idx="49">
                  <c:v>1.666746188384138E-2</c:v>
                </c:pt>
                <c:pt idx="50">
                  <c:v>2.5506885078753223E-2</c:v>
                </c:pt>
                <c:pt idx="51">
                  <c:v>2.161906117149678E-2</c:v>
                </c:pt>
                <c:pt idx="52">
                  <c:v>2.504596061123824E-2</c:v>
                </c:pt>
                <c:pt idx="53">
                  <c:v>2.3163158754345336E-2</c:v>
                </c:pt>
                <c:pt idx="54">
                  <c:v>2.714956469561456E-2</c:v>
                </c:pt>
                <c:pt idx="55">
                  <c:v>2.6762714101422863E-2</c:v>
                </c:pt>
                <c:pt idx="56">
                  <c:v>2.601801183234214E-2</c:v>
                </c:pt>
                <c:pt idx="57">
                  <c:v>2.7618644651601357E-2</c:v>
                </c:pt>
                <c:pt idx="58">
                  <c:v>3.0225103170164185E-2</c:v>
                </c:pt>
                <c:pt idx="59">
                  <c:v>3.369594589073905E-2</c:v>
                </c:pt>
                <c:pt idx="60">
                  <c:v>2.9164147246672632E-2</c:v>
                </c:pt>
                <c:pt idx="61">
                  <c:v>4.7540162529762266E-2</c:v>
                </c:pt>
                <c:pt idx="62">
                  <c:v>5.0947615190467845E-2</c:v>
                </c:pt>
                <c:pt idx="63">
                  <c:v>5.535133917424808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4C-464C-AEE6-74D09B04501C}"/>
            </c:ext>
          </c:extLst>
        </c:ser>
        <c:ser>
          <c:idx val="3"/>
          <c:order val="3"/>
          <c:tx>
            <c:strRef>
              <c:f>Feuil1!$E$3</c:f>
              <c:strCache>
                <c:ptCount val="1"/>
                <c:pt idx="0">
                  <c:v>HI</c:v>
                </c:pt>
              </c:strCache>
            </c:strRef>
          </c:tx>
          <c:spPr>
            <a:solidFill>
              <a:srgbClr val="42BC99"/>
            </a:solidFill>
            <a:ln>
              <a:noFill/>
            </a:ln>
            <a:effectLst/>
          </c:spPr>
          <c:invertIfNegative val="0"/>
          <c:cat>
            <c:strRef>
              <c:f>Feuil1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Feuil1!$E$4:$E$67</c:f>
              <c:numCache>
                <c:formatCode>General</c:formatCode>
                <c:ptCount val="64"/>
                <c:pt idx="0">
                  <c:v>6.3091303218318904E-4</c:v>
                </c:pt>
                <c:pt idx="1">
                  <c:v>7.7881864159148407E-4</c:v>
                </c:pt>
                <c:pt idx="2">
                  <c:v>8.7522470552389459E-4</c:v>
                </c:pt>
                <c:pt idx="3">
                  <c:v>2.5935839150228045E-3</c:v>
                </c:pt>
                <c:pt idx="4">
                  <c:v>3.8371033287111626E-3</c:v>
                </c:pt>
                <c:pt idx="5">
                  <c:v>3.9612676121174662E-3</c:v>
                </c:pt>
                <c:pt idx="6">
                  <c:v>4.1299685281432916E-3</c:v>
                </c:pt>
                <c:pt idx="7">
                  <c:v>4.7039646394623318E-3</c:v>
                </c:pt>
                <c:pt idx="8">
                  <c:v>4.763720763821107E-3</c:v>
                </c:pt>
                <c:pt idx="9">
                  <c:v>5.1722525419971343E-3</c:v>
                </c:pt>
                <c:pt idx="10">
                  <c:v>5.217010881765665E-3</c:v>
                </c:pt>
                <c:pt idx="11">
                  <c:v>5.6560129454721773E-3</c:v>
                </c:pt>
                <c:pt idx="12">
                  <c:v>6.1293837446120382E-3</c:v>
                </c:pt>
                <c:pt idx="13">
                  <c:v>6.5408106410617005E-3</c:v>
                </c:pt>
                <c:pt idx="14">
                  <c:v>6.5526963339496138E-3</c:v>
                </c:pt>
                <c:pt idx="15">
                  <c:v>8.0815908013414928E-3</c:v>
                </c:pt>
                <c:pt idx="16">
                  <c:v>8.145255324239464E-3</c:v>
                </c:pt>
                <c:pt idx="17">
                  <c:v>8.8109381511430138E-3</c:v>
                </c:pt>
                <c:pt idx="18">
                  <c:v>9.0443971567648173E-3</c:v>
                </c:pt>
                <c:pt idx="19">
                  <c:v>9.4866449145823168E-3</c:v>
                </c:pt>
                <c:pt idx="20">
                  <c:v>9.694234355162314E-3</c:v>
                </c:pt>
                <c:pt idx="21">
                  <c:v>9.7379039033551225E-3</c:v>
                </c:pt>
                <c:pt idx="22">
                  <c:v>1.0043539725223974E-2</c:v>
                </c:pt>
                <c:pt idx="23">
                  <c:v>1.0095948685333513E-2</c:v>
                </c:pt>
                <c:pt idx="24">
                  <c:v>1.0259853584458814E-2</c:v>
                </c:pt>
                <c:pt idx="25">
                  <c:v>1.0805581075623323E-2</c:v>
                </c:pt>
                <c:pt idx="26">
                  <c:v>1.0925194348876472E-2</c:v>
                </c:pt>
                <c:pt idx="27">
                  <c:v>1.2081023484442861E-2</c:v>
                </c:pt>
                <c:pt idx="28">
                  <c:v>1.2383657445317704E-2</c:v>
                </c:pt>
                <c:pt idx="29">
                  <c:v>1.2851397645333931E-2</c:v>
                </c:pt>
                <c:pt idx="30">
                  <c:v>1.384891452973676E-2</c:v>
                </c:pt>
                <c:pt idx="31">
                  <c:v>1.4307918872953409E-2</c:v>
                </c:pt>
                <c:pt idx="32">
                  <c:v>1.4757993539638423E-2</c:v>
                </c:pt>
                <c:pt idx="33">
                  <c:v>1.4781580595076409E-2</c:v>
                </c:pt>
                <c:pt idx="34">
                  <c:v>1.4958679266443332E-2</c:v>
                </c:pt>
                <c:pt idx="35">
                  <c:v>1.5035367322505509E-2</c:v>
                </c:pt>
                <c:pt idx="36">
                  <c:v>1.5284214869883401E-2</c:v>
                </c:pt>
                <c:pt idx="37">
                  <c:v>1.6801923445380222E-2</c:v>
                </c:pt>
                <c:pt idx="38">
                  <c:v>1.7076756630411239E-2</c:v>
                </c:pt>
                <c:pt idx="39">
                  <c:v>1.7980971673558659E-2</c:v>
                </c:pt>
                <c:pt idx="40">
                  <c:v>1.8597527936026315E-2</c:v>
                </c:pt>
                <c:pt idx="41">
                  <c:v>1.88223200985531E-2</c:v>
                </c:pt>
                <c:pt idx="42">
                  <c:v>1.8823149926371619E-2</c:v>
                </c:pt>
                <c:pt idx="43">
                  <c:v>1.9330366008621994E-2</c:v>
                </c:pt>
                <c:pt idx="44">
                  <c:v>1.9434037164263451E-2</c:v>
                </c:pt>
                <c:pt idx="45">
                  <c:v>1.9660843642204912E-2</c:v>
                </c:pt>
                <c:pt idx="46">
                  <c:v>1.985375806612627E-2</c:v>
                </c:pt>
                <c:pt idx="47">
                  <c:v>1.9859677110096421E-2</c:v>
                </c:pt>
                <c:pt idx="48">
                  <c:v>1.9940784815566468E-2</c:v>
                </c:pt>
                <c:pt idx="49">
                  <c:v>2.1252251095455726E-2</c:v>
                </c:pt>
                <c:pt idx="50">
                  <c:v>2.1882809068283632E-2</c:v>
                </c:pt>
                <c:pt idx="51">
                  <c:v>2.3469198008086684E-2</c:v>
                </c:pt>
                <c:pt idx="52">
                  <c:v>2.4096904197069113E-2</c:v>
                </c:pt>
                <c:pt idx="53">
                  <c:v>2.4964815804553484E-2</c:v>
                </c:pt>
                <c:pt idx="54">
                  <c:v>2.5040694035529311E-2</c:v>
                </c:pt>
                <c:pt idx="55">
                  <c:v>2.5416133298432668E-2</c:v>
                </c:pt>
                <c:pt idx="56">
                  <c:v>2.6183815127846666E-2</c:v>
                </c:pt>
                <c:pt idx="57">
                  <c:v>2.721541891033746E-2</c:v>
                </c:pt>
                <c:pt idx="58">
                  <c:v>2.9414110668972152E-2</c:v>
                </c:pt>
                <c:pt idx="59">
                  <c:v>3.0173134285523581E-2</c:v>
                </c:pt>
                <c:pt idx="60">
                  <c:v>3.0678131759599468E-2</c:v>
                </c:pt>
                <c:pt idx="61">
                  <c:v>4.5400222326509941E-2</c:v>
                </c:pt>
                <c:pt idx="62">
                  <c:v>5.0119590160583226E-2</c:v>
                </c:pt>
                <c:pt idx="63">
                  <c:v>5.15460928831647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E4C-464C-AEE6-74D09B0450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9086752"/>
        <c:axId val="1614757872"/>
      </c:barChart>
      <c:catAx>
        <c:axId val="1619086752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14757872"/>
        <c:crosses val="autoZero"/>
        <c:auto val="1"/>
        <c:lblAlgn val="ctr"/>
        <c:lblOffset val="100"/>
        <c:noMultiLvlLbl val="0"/>
      </c:catAx>
      <c:valAx>
        <c:axId val="1614757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19086752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5576907145986159"/>
          <c:y val="1.6313984576031719E-2"/>
          <c:w val="0.57041871753052031"/>
          <c:h val="2.65428329743741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b="1" dirty="0">
                <a:solidFill>
                  <a:schemeClr val="tx1"/>
                </a:solidFill>
              </a:rPr>
              <a:t>BC</a:t>
            </a:r>
            <a:endParaRPr lang="fr-FR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0855396825396828"/>
          <c:y val="1.76830057211110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BI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I$4:$BI$67</c:f>
              <c:numCache>
                <c:formatCode>General</c:formatCode>
                <c:ptCount val="64"/>
                <c:pt idx="0">
                  <c:v>5.6921271908003134E-4</c:v>
                </c:pt>
                <c:pt idx="1">
                  <c:v>7.8985870282008441E-4</c:v>
                </c:pt>
                <c:pt idx="2">
                  <c:v>7.0079998654311163E-4</c:v>
                </c:pt>
                <c:pt idx="3">
                  <c:v>2.8035062678605487E-3</c:v>
                </c:pt>
                <c:pt idx="4">
                  <c:v>3.7164831309052897E-3</c:v>
                </c:pt>
                <c:pt idx="5">
                  <c:v>3.8646184809225811E-3</c:v>
                </c:pt>
                <c:pt idx="6">
                  <c:v>5.0624456391384597E-3</c:v>
                </c:pt>
                <c:pt idx="7">
                  <c:v>4.963114241427675E-3</c:v>
                </c:pt>
                <c:pt idx="8">
                  <c:v>4.9057820426887779E-3</c:v>
                </c:pt>
                <c:pt idx="9">
                  <c:v>6.0070218279897258E-3</c:v>
                </c:pt>
                <c:pt idx="10">
                  <c:v>6.0247790248780918E-3</c:v>
                </c:pt>
                <c:pt idx="11">
                  <c:v>5.8140094068237858E-3</c:v>
                </c:pt>
                <c:pt idx="12">
                  <c:v>5.9647987144183442E-3</c:v>
                </c:pt>
                <c:pt idx="13">
                  <c:v>7.116036194125098E-3</c:v>
                </c:pt>
                <c:pt idx="14">
                  <c:v>6.4047529597015982E-3</c:v>
                </c:pt>
                <c:pt idx="15">
                  <c:v>9.9944717031020709E-3</c:v>
                </c:pt>
                <c:pt idx="16">
                  <c:v>9.5959427459576113E-3</c:v>
                </c:pt>
                <c:pt idx="17">
                  <c:v>1.0103972033586697E-2</c:v>
                </c:pt>
                <c:pt idx="18">
                  <c:v>9.2007748182807367E-3</c:v>
                </c:pt>
                <c:pt idx="19">
                  <c:v>8.2215759042276945E-3</c:v>
                </c:pt>
                <c:pt idx="20">
                  <c:v>9.6394749319004772E-3</c:v>
                </c:pt>
                <c:pt idx="21">
                  <c:v>7.8961625720407897E-3</c:v>
                </c:pt>
                <c:pt idx="22">
                  <c:v>1.0369676773884499E-2</c:v>
                </c:pt>
                <c:pt idx="23">
                  <c:v>9.9805745200152538E-3</c:v>
                </c:pt>
                <c:pt idx="24">
                  <c:v>1.0501249238989221E-2</c:v>
                </c:pt>
                <c:pt idx="25">
                  <c:v>9.6756328226094684E-3</c:v>
                </c:pt>
                <c:pt idx="26">
                  <c:v>1.1233168891440026E-2</c:v>
                </c:pt>
                <c:pt idx="27">
                  <c:v>1.2490225832687859E-2</c:v>
                </c:pt>
                <c:pt idx="28">
                  <c:v>1.0745636453597336E-2</c:v>
                </c:pt>
                <c:pt idx="29">
                  <c:v>1.5563851689765098E-2</c:v>
                </c:pt>
                <c:pt idx="30">
                  <c:v>1.340268960578677E-2</c:v>
                </c:pt>
                <c:pt idx="31">
                  <c:v>1.7292497291923416E-2</c:v>
                </c:pt>
                <c:pt idx="32">
                  <c:v>1.6054849368502929E-2</c:v>
                </c:pt>
                <c:pt idx="33">
                  <c:v>1.2590872641630049E-2</c:v>
                </c:pt>
                <c:pt idx="34">
                  <c:v>1.3943616759347006E-2</c:v>
                </c:pt>
                <c:pt idx="35">
                  <c:v>1.4466136566695603E-2</c:v>
                </c:pt>
                <c:pt idx="36">
                  <c:v>1.4419385715055334E-2</c:v>
                </c:pt>
                <c:pt idx="37">
                  <c:v>1.8317941391574877E-2</c:v>
                </c:pt>
                <c:pt idx="38">
                  <c:v>1.5894860711988357E-2</c:v>
                </c:pt>
                <c:pt idx="39">
                  <c:v>1.390841066484586E-2</c:v>
                </c:pt>
                <c:pt idx="40">
                  <c:v>1.7004857223410594E-2</c:v>
                </c:pt>
                <c:pt idx="41">
                  <c:v>2.2225521961135381E-2</c:v>
                </c:pt>
                <c:pt idx="42">
                  <c:v>1.853151469668831E-2</c:v>
                </c:pt>
                <c:pt idx="43">
                  <c:v>1.7911217018741182E-2</c:v>
                </c:pt>
                <c:pt idx="44">
                  <c:v>1.5852450716277805E-2</c:v>
                </c:pt>
                <c:pt idx="45">
                  <c:v>1.86965194878972E-2</c:v>
                </c:pt>
                <c:pt idx="46">
                  <c:v>1.4723197518947028E-2</c:v>
                </c:pt>
                <c:pt idx="47">
                  <c:v>1.7289094378540613E-2</c:v>
                </c:pt>
                <c:pt idx="48">
                  <c:v>2.1078980026893679E-2</c:v>
                </c:pt>
                <c:pt idx="49">
                  <c:v>1.666746188384138E-2</c:v>
                </c:pt>
                <c:pt idx="50">
                  <c:v>2.5506885078753223E-2</c:v>
                </c:pt>
                <c:pt idx="51">
                  <c:v>2.161906117149678E-2</c:v>
                </c:pt>
                <c:pt idx="52">
                  <c:v>2.504596061123824E-2</c:v>
                </c:pt>
                <c:pt idx="53">
                  <c:v>2.3163158754345336E-2</c:v>
                </c:pt>
                <c:pt idx="54">
                  <c:v>2.714956469561456E-2</c:v>
                </c:pt>
                <c:pt idx="55">
                  <c:v>2.6762714101422863E-2</c:v>
                </c:pt>
                <c:pt idx="56">
                  <c:v>2.601801183234214E-2</c:v>
                </c:pt>
                <c:pt idx="57">
                  <c:v>2.7618644651601357E-2</c:v>
                </c:pt>
                <c:pt idx="58">
                  <c:v>3.0225103170164185E-2</c:v>
                </c:pt>
                <c:pt idx="59">
                  <c:v>3.369594589073905E-2</c:v>
                </c:pt>
                <c:pt idx="60">
                  <c:v>2.9164147246672632E-2</c:v>
                </c:pt>
                <c:pt idx="61">
                  <c:v>4.7540162529762266E-2</c:v>
                </c:pt>
                <c:pt idx="62">
                  <c:v>5.0947615190467845E-2</c:v>
                </c:pt>
                <c:pt idx="63">
                  <c:v>5.535133917424808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A2-4C3C-BDE0-B1AFCE983671}"/>
            </c:ext>
          </c:extLst>
        </c:ser>
        <c:ser>
          <c:idx val="1"/>
          <c:order val="1"/>
          <c:tx>
            <c:strRef>
              <c:f>'Freq HI DSP SSP'!$BJ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J$4:$BJ$67</c:f>
              <c:numCache>
                <c:formatCode>General</c:formatCode>
                <c:ptCount val="64"/>
                <c:pt idx="0">
                  <c:v>4.8870705444838093E-4</c:v>
                </c:pt>
                <c:pt idx="1">
                  <c:v>8.1240653135067592E-4</c:v>
                </c:pt>
                <c:pt idx="2">
                  <c:v>7.153974534691587E-4</c:v>
                </c:pt>
                <c:pt idx="3">
                  <c:v>2.8440456790081699E-3</c:v>
                </c:pt>
                <c:pt idx="4">
                  <c:v>3.7538741247232169E-3</c:v>
                </c:pt>
                <c:pt idx="5">
                  <c:v>3.9312335797961721E-3</c:v>
                </c:pt>
                <c:pt idx="6">
                  <c:v>4.9101899187016405E-3</c:v>
                </c:pt>
                <c:pt idx="7">
                  <c:v>4.9727914423337025E-3</c:v>
                </c:pt>
                <c:pt idx="8">
                  <c:v>4.945900811557798E-3</c:v>
                </c:pt>
                <c:pt idx="9">
                  <c:v>5.6116892779161896E-3</c:v>
                </c:pt>
                <c:pt idx="10">
                  <c:v>6.1528637533766993E-3</c:v>
                </c:pt>
                <c:pt idx="11">
                  <c:v>5.912924097146428E-3</c:v>
                </c:pt>
                <c:pt idx="12">
                  <c:v>6.0621608375661662E-3</c:v>
                </c:pt>
                <c:pt idx="13">
                  <c:v>7.1975495154210341E-3</c:v>
                </c:pt>
                <c:pt idx="14">
                  <c:v>5.9248864274519123E-3</c:v>
                </c:pt>
                <c:pt idx="15">
                  <c:v>1.0160155837259823E-2</c:v>
                </c:pt>
                <c:pt idx="16">
                  <c:v>9.6905208117860197E-3</c:v>
                </c:pt>
                <c:pt idx="17">
                  <c:v>9.6132007830935454E-3</c:v>
                </c:pt>
                <c:pt idx="18">
                  <c:v>9.2927890896610174E-3</c:v>
                </c:pt>
                <c:pt idx="19">
                  <c:v>8.3199284864332174E-3</c:v>
                </c:pt>
                <c:pt idx="20">
                  <c:v>9.7680183371562437E-3</c:v>
                </c:pt>
                <c:pt idx="21">
                  <c:v>8.0102362142414046E-3</c:v>
                </c:pt>
                <c:pt idx="22">
                  <c:v>1.055169903471362E-2</c:v>
                </c:pt>
                <c:pt idx="23">
                  <c:v>1.0118559474041243E-2</c:v>
                </c:pt>
                <c:pt idx="24">
                  <c:v>1.0677911629783085E-2</c:v>
                </c:pt>
                <c:pt idx="25">
                  <c:v>9.7357862789106304E-3</c:v>
                </c:pt>
                <c:pt idx="26">
                  <c:v>1.146059212783563E-2</c:v>
                </c:pt>
                <c:pt idx="27">
                  <c:v>1.2654773081289775E-2</c:v>
                </c:pt>
                <c:pt idx="28">
                  <c:v>1.0612664749938132E-2</c:v>
                </c:pt>
                <c:pt idx="29">
                  <c:v>1.4652610493030974E-2</c:v>
                </c:pt>
                <c:pt idx="30">
                  <c:v>1.3547941411730562E-2</c:v>
                </c:pt>
                <c:pt idx="31">
                  <c:v>1.7156063566850389E-2</c:v>
                </c:pt>
                <c:pt idx="32">
                  <c:v>1.5828932838847717E-2</c:v>
                </c:pt>
                <c:pt idx="33">
                  <c:v>1.2773622070209156E-2</c:v>
                </c:pt>
                <c:pt idx="34">
                  <c:v>1.4120791560038169E-2</c:v>
                </c:pt>
                <c:pt idx="35">
                  <c:v>1.3429884869640569E-2</c:v>
                </c:pt>
                <c:pt idx="36">
                  <c:v>1.4265508175668552E-2</c:v>
                </c:pt>
                <c:pt idx="37">
                  <c:v>1.8574071422256713E-2</c:v>
                </c:pt>
                <c:pt idx="38">
                  <c:v>1.5286937605676237E-2</c:v>
                </c:pt>
                <c:pt idx="39">
                  <c:v>1.4054313412472654E-2</c:v>
                </c:pt>
                <c:pt idx="40">
                  <c:v>1.6845304074218029E-2</c:v>
                </c:pt>
                <c:pt idx="41">
                  <c:v>2.1893019831998775E-2</c:v>
                </c:pt>
                <c:pt idx="42">
                  <c:v>1.8667113453148206E-2</c:v>
                </c:pt>
                <c:pt idx="43">
                  <c:v>1.7715671118609153E-2</c:v>
                </c:pt>
                <c:pt idx="44">
                  <c:v>1.6029898800168942E-2</c:v>
                </c:pt>
                <c:pt idx="45">
                  <c:v>1.9043871525329395E-2</c:v>
                </c:pt>
                <c:pt idx="46">
                  <c:v>1.4901803971056272E-2</c:v>
                </c:pt>
                <c:pt idx="47">
                  <c:v>1.7506942619078768E-2</c:v>
                </c:pt>
                <c:pt idx="48">
                  <c:v>2.1239902309101225E-2</c:v>
                </c:pt>
                <c:pt idx="49">
                  <c:v>1.6839437081152611E-2</c:v>
                </c:pt>
                <c:pt idx="50">
                  <c:v>2.5341298557946451E-2</c:v>
                </c:pt>
                <c:pt idx="51">
                  <c:v>2.0298272816544203E-2</c:v>
                </c:pt>
                <c:pt idx="52">
                  <c:v>2.5392398389443384E-2</c:v>
                </c:pt>
                <c:pt idx="53">
                  <c:v>2.3458734500928502E-2</c:v>
                </c:pt>
                <c:pt idx="54">
                  <c:v>2.7397304136414752E-2</c:v>
                </c:pt>
                <c:pt idx="55">
                  <c:v>2.7085098202422008E-2</c:v>
                </c:pt>
                <c:pt idx="56">
                  <c:v>2.608246855642584E-2</c:v>
                </c:pt>
                <c:pt idx="57">
                  <c:v>2.7560516648546023E-2</c:v>
                </c:pt>
                <c:pt idx="58">
                  <c:v>3.0156052840920555E-2</c:v>
                </c:pt>
                <c:pt idx="59">
                  <c:v>3.3815035809372659E-2</c:v>
                </c:pt>
                <c:pt idx="60">
                  <c:v>2.9305926615454402E-2</c:v>
                </c:pt>
                <c:pt idx="61">
                  <c:v>4.7814549947942701E-2</c:v>
                </c:pt>
                <c:pt idx="62">
                  <c:v>5.1450491251193081E-2</c:v>
                </c:pt>
                <c:pt idx="63">
                  <c:v>5.55647530757516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A2-4C3C-BDE0-B1AFCE9836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6.0000000000000012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350715974483641"/>
          <c:y val="2.6037181652344604E-4"/>
          <c:w val="0.32693148211154444"/>
          <c:h val="4.105863260562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b="1" dirty="0">
                <a:solidFill>
                  <a:schemeClr val="tx1"/>
                </a:solidFill>
              </a:rPr>
              <a:t>NSCLC</a:t>
            </a:r>
            <a:endParaRPr lang="fr-FR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2791904761904767"/>
          <c:y val="1.49625433024785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BK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K$4:$BK$67</c:f>
              <c:numCache>
                <c:formatCode>General</c:formatCode>
                <c:ptCount val="64"/>
                <c:pt idx="0">
                  <c:v>5.2412512586779282E-4</c:v>
                </c:pt>
                <c:pt idx="1">
                  <c:v>7.3723451265978281E-4</c:v>
                </c:pt>
                <c:pt idx="2">
                  <c:v>5.7631782271602629E-4</c:v>
                </c:pt>
                <c:pt idx="3">
                  <c:v>2.3617584044467121E-3</c:v>
                </c:pt>
                <c:pt idx="4">
                  <c:v>3.3143272295148673E-3</c:v>
                </c:pt>
                <c:pt idx="5">
                  <c:v>3.224789698778333E-3</c:v>
                </c:pt>
                <c:pt idx="6">
                  <c:v>5.4547814225718739E-3</c:v>
                </c:pt>
                <c:pt idx="7">
                  <c:v>4.8041493213320961E-3</c:v>
                </c:pt>
                <c:pt idx="8">
                  <c:v>4.943394489104273E-3</c:v>
                </c:pt>
                <c:pt idx="9">
                  <c:v>5.9941215137352174E-3</c:v>
                </c:pt>
                <c:pt idx="10">
                  <c:v>6.3204044241730135E-3</c:v>
                </c:pt>
                <c:pt idx="11">
                  <c:v>5.679467379587055E-3</c:v>
                </c:pt>
                <c:pt idx="12">
                  <c:v>5.689496134555481E-3</c:v>
                </c:pt>
                <c:pt idx="13">
                  <c:v>7.2359179323360735E-3</c:v>
                </c:pt>
                <c:pt idx="14">
                  <c:v>5.9117451641760603E-3</c:v>
                </c:pt>
                <c:pt idx="15">
                  <c:v>1.0933781043014004E-2</c:v>
                </c:pt>
                <c:pt idx="16">
                  <c:v>1.0455464575489527E-2</c:v>
                </c:pt>
                <c:pt idx="17">
                  <c:v>9.7381844787710198E-3</c:v>
                </c:pt>
                <c:pt idx="18">
                  <c:v>9.6446232277788025E-3</c:v>
                </c:pt>
                <c:pt idx="19">
                  <c:v>7.9929840620465691E-3</c:v>
                </c:pt>
                <c:pt idx="20">
                  <c:v>9.7631150736338605E-3</c:v>
                </c:pt>
                <c:pt idx="21">
                  <c:v>7.3308535362609801E-3</c:v>
                </c:pt>
                <c:pt idx="22">
                  <c:v>9.923991508204685E-3</c:v>
                </c:pt>
                <c:pt idx="23">
                  <c:v>9.7963241352371812E-3</c:v>
                </c:pt>
                <c:pt idx="24">
                  <c:v>1.0702873464699376E-2</c:v>
                </c:pt>
                <c:pt idx="25">
                  <c:v>9.6114062555640624E-3</c:v>
                </c:pt>
                <c:pt idx="26">
                  <c:v>1.1906505556649027E-2</c:v>
                </c:pt>
                <c:pt idx="27">
                  <c:v>1.2761337837412031E-2</c:v>
                </c:pt>
                <c:pt idx="28">
                  <c:v>1.035042412163242E-2</c:v>
                </c:pt>
                <c:pt idx="29">
                  <c:v>1.6057817384848412E-2</c:v>
                </c:pt>
                <c:pt idx="30">
                  <c:v>1.3603324270462304E-2</c:v>
                </c:pt>
                <c:pt idx="31">
                  <c:v>1.8395602542859969E-2</c:v>
                </c:pt>
                <c:pt idx="32">
                  <c:v>1.5910893723380899E-2</c:v>
                </c:pt>
                <c:pt idx="33">
                  <c:v>1.1193094263225475E-2</c:v>
                </c:pt>
                <c:pt idx="34">
                  <c:v>1.4400546545669701E-2</c:v>
                </c:pt>
                <c:pt idx="35">
                  <c:v>1.4402140833540857E-2</c:v>
                </c:pt>
                <c:pt idx="36">
                  <c:v>1.4618498789792102E-2</c:v>
                </c:pt>
                <c:pt idx="37">
                  <c:v>1.8549702696819378E-2</c:v>
                </c:pt>
                <c:pt idx="38">
                  <c:v>1.5806316658970955E-2</c:v>
                </c:pt>
                <c:pt idx="39">
                  <c:v>1.3223703776790849E-2</c:v>
                </c:pt>
                <c:pt idx="40">
                  <c:v>1.6139933720694086E-2</c:v>
                </c:pt>
                <c:pt idx="41">
                  <c:v>2.1937274793500165E-2</c:v>
                </c:pt>
                <c:pt idx="42">
                  <c:v>1.898592021314139E-2</c:v>
                </c:pt>
                <c:pt idx="43">
                  <c:v>1.6364265347006909E-2</c:v>
                </c:pt>
                <c:pt idx="44">
                  <c:v>1.418343061120555E-2</c:v>
                </c:pt>
                <c:pt idx="45">
                  <c:v>1.8523052771922538E-2</c:v>
                </c:pt>
                <c:pt idx="46">
                  <c:v>1.394392889821972E-2</c:v>
                </c:pt>
                <c:pt idx="47">
                  <c:v>1.6502258163768251E-2</c:v>
                </c:pt>
                <c:pt idx="48">
                  <c:v>2.1421015024723412E-2</c:v>
                </c:pt>
                <c:pt idx="49">
                  <c:v>1.5382946425398027E-2</c:v>
                </c:pt>
                <c:pt idx="50">
                  <c:v>2.7626894442400258E-2</c:v>
                </c:pt>
                <c:pt idx="51">
                  <c:v>2.2233638387048733E-2</c:v>
                </c:pt>
                <c:pt idx="52">
                  <c:v>2.3608187826992189E-2</c:v>
                </c:pt>
                <c:pt idx="53">
                  <c:v>2.1719008527109254E-2</c:v>
                </c:pt>
                <c:pt idx="54">
                  <c:v>2.8928271921191025E-2</c:v>
                </c:pt>
                <c:pt idx="55">
                  <c:v>2.7837764431322125E-2</c:v>
                </c:pt>
                <c:pt idx="56">
                  <c:v>2.7329914165016338E-2</c:v>
                </c:pt>
                <c:pt idx="57">
                  <c:v>2.7763427658719413E-2</c:v>
                </c:pt>
                <c:pt idx="58">
                  <c:v>2.9836187237670838E-2</c:v>
                </c:pt>
                <c:pt idx="59">
                  <c:v>3.5191772278718982E-2</c:v>
                </c:pt>
                <c:pt idx="60">
                  <c:v>2.8986414249479203E-2</c:v>
                </c:pt>
                <c:pt idx="61">
                  <c:v>4.7419009533959645E-2</c:v>
                </c:pt>
                <c:pt idx="62">
                  <c:v>5.1914742436994489E-2</c:v>
                </c:pt>
                <c:pt idx="63">
                  <c:v>5.637519999548834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F4-4D46-B19D-126528AC6C35}"/>
            </c:ext>
          </c:extLst>
        </c:ser>
        <c:ser>
          <c:idx val="1"/>
          <c:order val="1"/>
          <c:tx>
            <c:strRef>
              <c:f>'Freq HI DSP SSP'!$BL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L$4:$BL$67</c:f>
              <c:numCache>
                <c:formatCode>General</c:formatCode>
                <c:ptCount val="64"/>
                <c:pt idx="0">
                  <c:v>4.275425439704377E-4</c:v>
                </c:pt>
                <c:pt idx="1">
                  <c:v>7.5212486508999656E-4</c:v>
                </c:pt>
                <c:pt idx="2">
                  <c:v>5.9347015199747236E-4</c:v>
                </c:pt>
                <c:pt idx="3">
                  <c:v>2.4011005309981059E-3</c:v>
                </c:pt>
                <c:pt idx="4">
                  <c:v>3.3495970884597657E-3</c:v>
                </c:pt>
                <c:pt idx="5">
                  <c:v>3.2956127438644083E-3</c:v>
                </c:pt>
                <c:pt idx="6">
                  <c:v>5.2754762842084149E-3</c:v>
                </c:pt>
                <c:pt idx="7">
                  <c:v>4.8283251468061025E-3</c:v>
                </c:pt>
                <c:pt idx="8">
                  <c:v>5.0229663449049711E-3</c:v>
                </c:pt>
                <c:pt idx="9">
                  <c:v>5.5427708571325904E-3</c:v>
                </c:pt>
                <c:pt idx="10">
                  <c:v>6.4740484196165252E-3</c:v>
                </c:pt>
                <c:pt idx="11">
                  <c:v>5.8055887322949144E-3</c:v>
                </c:pt>
                <c:pt idx="12">
                  <c:v>5.8051057818839071E-3</c:v>
                </c:pt>
                <c:pt idx="13">
                  <c:v>7.3301684361084026E-3</c:v>
                </c:pt>
                <c:pt idx="14">
                  <c:v>5.3344242944585356E-3</c:v>
                </c:pt>
                <c:pt idx="15">
                  <c:v>1.1078243763713164E-2</c:v>
                </c:pt>
                <c:pt idx="16">
                  <c:v>1.058095621830667E-2</c:v>
                </c:pt>
                <c:pt idx="17">
                  <c:v>9.1677605577617817E-3</c:v>
                </c:pt>
                <c:pt idx="18">
                  <c:v>9.7774395534829545E-3</c:v>
                </c:pt>
                <c:pt idx="19">
                  <c:v>8.0979703217047075E-3</c:v>
                </c:pt>
                <c:pt idx="20">
                  <c:v>9.9238242769854428E-3</c:v>
                </c:pt>
                <c:pt idx="21">
                  <c:v>7.4643193974917562E-3</c:v>
                </c:pt>
                <c:pt idx="22">
                  <c:v>1.011956315451662E-2</c:v>
                </c:pt>
                <c:pt idx="23">
                  <c:v>9.9511906063111649E-3</c:v>
                </c:pt>
                <c:pt idx="24">
                  <c:v>1.0890143714710162E-2</c:v>
                </c:pt>
                <c:pt idx="25">
                  <c:v>9.6834556472890684E-3</c:v>
                </c:pt>
                <c:pt idx="26">
                  <c:v>1.2167934475059386E-2</c:v>
                </c:pt>
                <c:pt idx="27">
                  <c:v>1.3005435508276314E-2</c:v>
                </c:pt>
                <c:pt idx="28">
                  <c:v>1.0188139050073418E-2</c:v>
                </c:pt>
                <c:pt idx="29">
                  <c:v>1.506474639650307E-2</c:v>
                </c:pt>
                <c:pt idx="30">
                  <c:v>1.3772989147997171E-2</c:v>
                </c:pt>
                <c:pt idx="31">
                  <c:v>1.8274911393402728E-2</c:v>
                </c:pt>
                <c:pt idx="32">
                  <c:v>1.5635629415084024E-2</c:v>
                </c:pt>
                <c:pt idx="33">
                  <c:v>1.136346842283191E-2</c:v>
                </c:pt>
                <c:pt idx="34">
                  <c:v>1.460150166526567E-2</c:v>
                </c:pt>
                <c:pt idx="35">
                  <c:v>1.3204597355810388E-2</c:v>
                </c:pt>
                <c:pt idx="36">
                  <c:v>1.4468368047282831E-2</c:v>
                </c:pt>
                <c:pt idx="37">
                  <c:v>1.8903841980919656E-2</c:v>
                </c:pt>
                <c:pt idx="38">
                  <c:v>1.5086428299146816E-2</c:v>
                </c:pt>
                <c:pt idx="39">
                  <c:v>1.3384527077021964E-2</c:v>
                </c:pt>
                <c:pt idx="40">
                  <c:v>1.5961895885040767E-2</c:v>
                </c:pt>
                <c:pt idx="41">
                  <c:v>2.1619923624682364E-2</c:v>
                </c:pt>
                <c:pt idx="42">
                  <c:v>1.9129706777370869E-2</c:v>
                </c:pt>
                <c:pt idx="43">
                  <c:v>1.6105563703758714E-2</c:v>
                </c:pt>
                <c:pt idx="44">
                  <c:v>1.4378491033715714E-2</c:v>
                </c:pt>
                <c:pt idx="45">
                  <c:v>1.8922490559099701E-2</c:v>
                </c:pt>
                <c:pt idx="46">
                  <c:v>1.4108440040675158E-2</c:v>
                </c:pt>
                <c:pt idx="47">
                  <c:v>1.6730151415171469E-2</c:v>
                </c:pt>
                <c:pt idx="48">
                  <c:v>2.1634627210078135E-2</c:v>
                </c:pt>
                <c:pt idx="49">
                  <c:v>1.5586464301665912E-2</c:v>
                </c:pt>
                <c:pt idx="50">
                  <c:v>2.7435524686483432E-2</c:v>
                </c:pt>
                <c:pt idx="51">
                  <c:v>2.0609471613712245E-2</c:v>
                </c:pt>
                <c:pt idx="52">
                  <c:v>2.3947288499739351E-2</c:v>
                </c:pt>
                <c:pt idx="53">
                  <c:v>2.2057903947601543E-2</c:v>
                </c:pt>
                <c:pt idx="54">
                  <c:v>2.9199052391079405E-2</c:v>
                </c:pt>
                <c:pt idx="55">
                  <c:v>2.8271365067740303E-2</c:v>
                </c:pt>
                <c:pt idx="56">
                  <c:v>2.7387934371332859E-2</c:v>
                </c:pt>
                <c:pt idx="57">
                  <c:v>2.7692151745769278E-2</c:v>
                </c:pt>
                <c:pt idx="58">
                  <c:v>2.9796872045738519E-2</c:v>
                </c:pt>
                <c:pt idx="59">
                  <c:v>3.5366455299739821E-2</c:v>
                </c:pt>
                <c:pt idx="60">
                  <c:v>2.9104007757897839E-2</c:v>
                </c:pt>
                <c:pt idx="61">
                  <c:v>4.7718505005422983E-2</c:v>
                </c:pt>
                <c:pt idx="62">
                  <c:v>5.2520374661852588E-2</c:v>
                </c:pt>
                <c:pt idx="63">
                  <c:v>5.661963068588760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3F4-4D46-B19D-126528AC6C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6.0000000000000012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350715974483641"/>
          <c:y val="2.6037181652344604E-4"/>
          <c:w val="0.32693148211154444"/>
          <c:h val="4.105863260562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b="1" dirty="0" err="1">
                <a:solidFill>
                  <a:schemeClr val="tx1"/>
                </a:solidFill>
              </a:rPr>
              <a:t>mCRC</a:t>
            </a:r>
            <a:endParaRPr lang="fr-FR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9.1053861433943256E-2"/>
          <c:y val="1.49625433024785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AS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S$4:$AS$67</c:f>
              <c:numCache>
                <c:formatCode>General</c:formatCode>
                <c:ptCount val="64"/>
                <c:pt idx="0">
                  <c:v>1.1256999043050672E-3</c:v>
                </c:pt>
                <c:pt idx="1">
                  <c:v>9.9542959805862209E-4</c:v>
                </c:pt>
                <c:pt idx="2">
                  <c:v>9.6007028509582915E-4</c:v>
                </c:pt>
                <c:pt idx="3">
                  <c:v>2.7493148784668089E-3</c:v>
                </c:pt>
                <c:pt idx="4">
                  <c:v>3.3945989205330517E-3</c:v>
                </c:pt>
                <c:pt idx="5">
                  <c:v>3.58318174112614E-3</c:v>
                </c:pt>
                <c:pt idx="6">
                  <c:v>5.5770329186657121E-3</c:v>
                </c:pt>
                <c:pt idx="7">
                  <c:v>4.1802546244154564E-3</c:v>
                </c:pt>
                <c:pt idx="8">
                  <c:v>5.2603846607363969E-3</c:v>
                </c:pt>
                <c:pt idx="9">
                  <c:v>8.9032254019188965E-3</c:v>
                </c:pt>
                <c:pt idx="10">
                  <c:v>6.9006205274980978E-3</c:v>
                </c:pt>
                <c:pt idx="11">
                  <c:v>4.6003942757685701E-3</c:v>
                </c:pt>
                <c:pt idx="12">
                  <c:v>7.1376917761548841E-3</c:v>
                </c:pt>
                <c:pt idx="13">
                  <c:v>7.172205056879712E-3</c:v>
                </c:pt>
                <c:pt idx="14">
                  <c:v>1.0259129286687227E-2</c:v>
                </c:pt>
                <c:pt idx="15">
                  <c:v>9.8622815739332331E-3</c:v>
                </c:pt>
                <c:pt idx="16">
                  <c:v>9.1919944313690223E-3</c:v>
                </c:pt>
                <c:pt idx="17">
                  <c:v>1.3619553333906092E-2</c:v>
                </c:pt>
                <c:pt idx="18">
                  <c:v>9.1480241929721342E-3</c:v>
                </c:pt>
                <c:pt idx="19">
                  <c:v>8.6207150550853227E-3</c:v>
                </c:pt>
                <c:pt idx="20">
                  <c:v>1.1146501351790964E-2</c:v>
                </c:pt>
                <c:pt idx="21">
                  <c:v>1.0157698713995873E-2</c:v>
                </c:pt>
                <c:pt idx="22">
                  <c:v>1.141040120907227E-2</c:v>
                </c:pt>
                <c:pt idx="23">
                  <c:v>9.8310126950799503E-3</c:v>
                </c:pt>
                <c:pt idx="24">
                  <c:v>1.0265295788024211E-2</c:v>
                </c:pt>
                <c:pt idx="25">
                  <c:v>1.058420859168881E-2</c:v>
                </c:pt>
                <c:pt idx="26">
                  <c:v>1.1620074159697064E-2</c:v>
                </c:pt>
                <c:pt idx="27">
                  <c:v>1.1800074067085919E-2</c:v>
                </c:pt>
                <c:pt idx="28">
                  <c:v>1.4311864004502141E-2</c:v>
                </c:pt>
                <c:pt idx="29">
                  <c:v>1.6246002019670365E-2</c:v>
                </c:pt>
                <c:pt idx="30">
                  <c:v>1.1597197058503131E-2</c:v>
                </c:pt>
                <c:pt idx="31">
                  <c:v>1.576392284130633E-2</c:v>
                </c:pt>
                <c:pt idx="32">
                  <c:v>1.7944035050930288E-2</c:v>
                </c:pt>
                <c:pt idx="33">
                  <c:v>1.2638645985096141E-2</c:v>
                </c:pt>
                <c:pt idx="34">
                  <c:v>1.2886224815185284E-2</c:v>
                </c:pt>
                <c:pt idx="35">
                  <c:v>1.626781690214979E-2</c:v>
                </c:pt>
                <c:pt idx="36">
                  <c:v>1.5979194547977374E-2</c:v>
                </c:pt>
                <c:pt idx="37">
                  <c:v>1.8190737488535835E-2</c:v>
                </c:pt>
                <c:pt idx="38">
                  <c:v>1.9209072504042819E-2</c:v>
                </c:pt>
                <c:pt idx="39">
                  <c:v>1.4987658269353301E-2</c:v>
                </c:pt>
                <c:pt idx="40">
                  <c:v>1.959285029447478E-2</c:v>
                </c:pt>
                <c:pt idx="41">
                  <c:v>2.1697126288823702E-2</c:v>
                </c:pt>
                <c:pt idx="42">
                  <c:v>1.6795664663149811E-2</c:v>
                </c:pt>
                <c:pt idx="43">
                  <c:v>2.2328799646573767E-2</c:v>
                </c:pt>
                <c:pt idx="44">
                  <c:v>1.5874073766366379E-2</c:v>
                </c:pt>
                <c:pt idx="45">
                  <c:v>2.0383680642539401E-2</c:v>
                </c:pt>
                <c:pt idx="46">
                  <c:v>1.6236613695790134E-2</c:v>
                </c:pt>
                <c:pt idx="47">
                  <c:v>1.6411763717905339E-2</c:v>
                </c:pt>
                <c:pt idx="48">
                  <c:v>1.9251519869822552E-2</c:v>
                </c:pt>
                <c:pt idx="49">
                  <c:v>1.6843846867180788E-2</c:v>
                </c:pt>
                <c:pt idx="50">
                  <c:v>2.3523904514467089E-2</c:v>
                </c:pt>
                <c:pt idx="51">
                  <c:v>2.5964960608284435E-2</c:v>
                </c:pt>
                <c:pt idx="52">
                  <c:v>2.4682696858417199E-2</c:v>
                </c:pt>
                <c:pt idx="53">
                  <c:v>2.1906918989053059E-2</c:v>
                </c:pt>
                <c:pt idx="54">
                  <c:v>2.4100931963105969E-2</c:v>
                </c:pt>
                <c:pt idx="55">
                  <c:v>2.8236153620380382E-2</c:v>
                </c:pt>
                <c:pt idx="56">
                  <c:v>2.7096312919638824E-2</c:v>
                </c:pt>
                <c:pt idx="57">
                  <c:v>3.1746992692008917E-2</c:v>
                </c:pt>
                <c:pt idx="58">
                  <c:v>3.2782953438999361E-2</c:v>
                </c:pt>
                <c:pt idx="59">
                  <c:v>3.0971616358383084E-2</c:v>
                </c:pt>
                <c:pt idx="60">
                  <c:v>3.041782136363921E-2</c:v>
                </c:pt>
                <c:pt idx="61">
                  <c:v>3.5331354065567776E-2</c:v>
                </c:pt>
                <c:pt idx="62">
                  <c:v>3.9637972283234749E-2</c:v>
                </c:pt>
                <c:pt idx="63">
                  <c:v>4.2104030364929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F6-453F-9A0B-D484B78AAB08}"/>
            </c:ext>
          </c:extLst>
        </c:ser>
        <c:ser>
          <c:idx val="1"/>
          <c:order val="1"/>
          <c:tx>
            <c:strRef>
              <c:f>'Freq HI DSP SSP'!$AT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T$4:$AT$67</c:f>
              <c:numCache>
                <c:formatCode>General</c:formatCode>
                <c:ptCount val="64"/>
                <c:pt idx="0">
                  <c:v>9.0304718787543811E-4</c:v>
                </c:pt>
                <c:pt idx="1">
                  <c:v>1.0485704134020827E-3</c:v>
                </c:pt>
                <c:pt idx="2">
                  <c:v>1.0120345977483675E-3</c:v>
                </c:pt>
                <c:pt idx="3">
                  <c:v>2.8348756847951517E-3</c:v>
                </c:pt>
                <c:pt idx="4">
                  <c:v>3.5240884890279599E-3</c:v>
                </c:pt>
                <c:pt idx="5">
                  <c:v>3.7566126450318603E-3</c:v>
                </c:pt>
                <c:pt idx="6">
                  <c:v>5.1562202610377916E-3</c:v>
                </c:pt>
                <c:pt idx="7">
                  <c:v>4.2891224316772185E-3</c:v>
                </c:pt>
                <c:pt idx="8">
                  <c:v>5.4246936105468851E-3</c:v>
                </c:pt>
                <c:pt idx="9">
                  <c:v>7.7829080073813818E-3</c:v>
                </c:pt>
                <c:pt idx="10">
                  <c:v>7.1858422772297882E-3</c:v>
                </c:pt>
                <c:pt idx="11">
                  <c:v>4.7986506053093016E-3</c:v>
                </c:pt>
                <c:pt idx="12">
                  <c:v>7.4127512241840155E-3</c:v>
                </c:pt>
                <c:pt idx="13">
                  <c:v>7.3879532988114036E-3</c:v>
                </c:pt>
                <c:pt idx="14">
                  <c:v>8.4615341165334076E-3</c:v>
                </c:pt>
                <c:pt idx="15">
                  <c:v>1.0161000309788832E-2</c:v>
                </c:pt>
                <c:pt idx="16">
                  <c:v>9.4324769602013685E-3</c:v>
                </c:pt>
                <c:pt idx="17">
                  <c:v>1.1685708914029976E-2</c:v>
                </c:pt>
                <c:pt idx="18">
                  <c:v>9.4891534398718544E-3</c:v>
                </c:pt>
                <c:pt idx="19">
                  <c:v>8.9317547045126913E-3</c:v>
                </c:pt>
                <c:pt idx="20">
                  <c:v>1.16694050998053E-2</c:v>
                </c:pt>
                <c:pt idx="21">
                  <c:v>1.058163388348936E-2</c:v>
                </c:pt>
                <c:pt idx="22">
                  <c:v>1.1904624226813513E-2</c:v>
                </c:pt>
                <c:pt idx="23">
                  <c:v>1.0268924522822425E-2</c:v>
                </c:pt>
                <c:pt idx="24">
                  <c:v>1.0644366972000146E-2</c:v>
                </c:pt>
                <c:pt idx="25">
                  <c:v>1.0747154951302287E-2</c:v>
                </c:pt>
                <c:pt idx="26">
                  <c:v>1.2158206553537729E-2</c:v>
                </c:pt>
                <c:pt idx="27">
                  <c:v>1.2275336630291652E-2</c:v>
                </c:pt>
                <c:pt idx="28">
                  <c:v>1.4188258918778366E-2</c:v>
                </c:pt>
                <c:pt idx="29">
                  <c:v>1.4179817497958488E-2</c:v>
                </c:pt>
                <c:pt idx="30">
                  <c:v>1.1917927904461167E-2</c:v>
                </c:pt>
                <c:pt idx="31">
                  <c:v>1.5290805908680153E-2</c:v>
                </c:pt>
                <c:pt idx="32">
                  <c:v>1.7027192042350672E-2</c:v>
                </c:pt>
                <c:pt idx="33">
                  <c:v>1.3072303455214171E-2</c:v>
                </c:pt>
                <c:pt idx="34">
                  <c:v>1.3240830468897567E-2</c:v>
                </c:pt>
                <c:pt idx="35">
                  <c:v>1.4700800506570218E-2</c:v>
                </c:pt>
                <c:pt idx="36">
                  <c:v>1.5990154401810786E-2</c:v>
                </c:pt>
                <c:pt idx="37">
                  <c:v>1.8949088700234172E-2</c:v>
                </c:pt>
                <c:pt idx="38">
                  <c:v>1.7813960050888863E-2</c:v>
                </c:pt>
                <c:pt idx="39">
                  <c:v>1.5418925022039998E-2</c:v>
                </c:pt>
                <c:pt idx="40">
                  <c:v>1.9203247587010055E-2</c:v>
                </c:pt>
                <c:pt idx="41">
                  <c:v>2.0233714428894736E-2</c:v>
                </c:pt>
                <c:pt idx="42">
                  <c:v>1.7198528024006607E-2</c:v>
                </c:pt>
                <c:pt idx="43">
                  <c:v>2.1804099265060158E-2</c:v>
                </c:pt>
                <c:pt idx="44">
                  <c:v>1.6405277801483497E-2</c:v>
                </c:pt>
                <c:pt idx="45">
                  <c:v>2.1344918874365786E-2</c:v>
                </c:pt>
                <c:pt idx="46">
                  <c:v>1.670202605040156E-2</c:v>
                </c:pt>
                <c:pt idx="47">
                  <c:v>1.6963476380239619E-2</c:v>
                </c:pt>
                <c:pt idx="48">
                  <c:v>1.9859374345935536E-2</c:v>
                </c:pt>
                <c:pt idx="49">
                  <c:v>1.736976195705723E-2</c:v>
                </c:pt>
                <c:pt idx="50">
                  <c:v>2.2015959002649483E-2</c:v>
                </c:pt>
                <c:pt idx="51">
                  <c:v>2.2231973187703168E-2</c:v>
                </c:pt>
                <c:pt idx="52">
                  <c:v>2.5571709986402246E-2</c:v>
                </c:pt>
                <c:pt idx="53">
                  <c:v>2.2704572922662664E-2</c:v>
                </c:pt>
                <c:pt idx="54">
                  <c:v>2.4783032240433874E-2</c:v>
                </c:pt>
                <c:pt idx="55">
                  <c:v>2.9404345764801731E-2</c:v>
                </c:pt>
                <c:pt idx="56">
                  <c:v>2.7468776795560243E-2</c:v>
                </c:pt>
                <c:pt idx="57">
                  <c:v>3.1823078744523461E-2</c:v>
                </c:pt>
                <c:pt idx="58">
                  <c:v>3.2540671914176519E-2</c:v>
                </c:pt>
                <c:pt idx="59">
                  <c:v>3.1760475087081672E-2</c:v>
                </c:pt>
                <c:pt idx="60">
                  <c:v>3.0574066304397234E-2</c:v>
                </c:pt>
                <c:pt idx="61">
                  <c:v>3.5971846897515293E-2</c:v>
                </c:pt>
                <c:pt idx="62">
                  <c:v>4.0533325968673477E-2</c:v>
                </c:pt>
                <c:pt idx="63">
                  <c:v>4.281302357202033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3F6-453F-9A0B-D484B78AAB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5.5000000000000007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5489288583373995"/>
          <c:y val="7.061527863104617E-3"/>
          <c:w val="0.32693148211154444"/>
          <c:h val="5.19404822801502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 dirty="0"/>
              <a:t>HI: </a:t>
            </a:r>
            <a:r>
              <a:rPr lang="fr-FR" dirty="0"/>
              <a:t>DSP 5' vs DSP 3' </a:t>
            </a:r>
          </a:p>
        </c:rich>
      </c:tx>
      <c:layout>
        <c:manualLayout>
          <c:xMode val="edge"/>
          <c:yMode val="edge"/>
          <c:x val="0.10149814814814814"/>
          <c:y val="8.259559740251809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B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B$4:$B$67</c:f>
              <c:numCache>
                <c:formatCode>General</c:formatCode>
                <c:ptCount val="64"/>
                <c:pt idx="0">
                  <c:v>6.3091303218318904E-4</c:v>
                </c:pt>
                <c:pt idx="1">
                  <c:v>7.7881864159148407E-4</c:v>
                </c:pt>
                <c:pt idx="2">
                  <c:v>8.7522470552389459E-4</c:v>
                </c:pt>
                <c:pt idx="3">
                  <c:v>2.5935839150228045E-3</c:v>
                </c:pt>
                <c:pt idx="4">
                  <c:v>3.8371033287111626E-3</c:v>
                </c:pt>
                <c:pt idx="5">
                  <c:v>3.9612676121174662E-3</c:v>
                </c:pt>
                <c:pt idx="6">
                  <c:v>4.1299685281432916E-3</c:v>
                </c:pt>
                <c:pt idx="7">
                  <c:v>4.7039646394623318E-3</c:v>
                </c:pt>
                <c:pt idx="8">
                  <c:v>4.763720763821107E-3</c:v>
                </c:pt>
                <c:pt idx="9">
                  <c:v>5.1722525419971343E-3</c:v>
                </c:pt>
                <c:pt idx="10">
                  <c:v>5.217010881765665E-3</c:v>
                </c:pt>
                <c:pt idx="11">
                  <c:v>5.6560129454721773E-3</c:v>
                </c:pt>
                <c:pt idx="12">
                  <c:v>6.1293837446120382E-3</c:v>
                </c:pt>
                <c:pt idx="13">
                  <c:v>6.5408106410617005E-3</c:v>
                </c:pt>
                <c:pt idx="14">
                  <c:v>6.5526963339496138E-3</c:v>
                </c:pt>
                <c:pt idx="15">
                  <c:v>8.0815908013414928E-3</c:v>
                </c:pt>
                <c:pt idx="16">
                  <c:v>8.145255324239464E-3</c:v>
                </c:pt>
                <c:pt idx="17">
                  <c:v>8.8109381511430138E-3</c:v>
                </c:pt>
                <c:pt idx="18">
                  <c:v>9.0443971567648173E-3</c:v>
                </c:pt>
                <c:pt idx="19">
                  <c:v>9.4866449145823168E-3</c:v>
                </c:pt>
                <c:pt idx="20">
                  <c:v>9.694234355162314E-3</c:v>
                </c:pt>
                <c:pt idx="21">
                  <c:v>9.7379039033551225E-3</c:v>
                </c:pt>
                <c:pt idx="22">
                  <c:v>1.0043539725223974E-2</c:v>
                </c:pt>
                <c:pt idx="23">
                  <c:v>1.0095948685333513E-2</c:v>
                </c:pt>
                <c:pt idx="24">
                  <c:v>1.0259853584458814E-2</c:v>
                </c:pt>
                <c:pt idx="25">
                  <c:v>1.0805581075623323E-2</c:v>
                </c:pt>
                <c:pt idx="26">
                  <c:v>1.0925194348876472E-2</c:v>
                </c:pt>
                <c:pt idx="27">
                  <c:v>1.2081023484442861E-2</c:v>
                </c:pt>
                <c:pt idx="28">
                  <c:v>1.2383657445317704E-2</c:v>
                </c:pt>
                <c:pt idx="29">
                  <c:v>1.2851397645333931E-2</c:v>
                </c:pt>
                <c:pt idx="30">
                  <c:v>1.384891452973676E-2</c:v>
                </c:pt>
                <c:pt idx="31">
                  <c:v>1.4307918872953409E-2</c:v>
                </c:pt>
                <c:pt idx="32">
                  <c:v>1.4757993539638423E-2</c:v>
                </c:pt>
                <c:pt idx="33">
                  <c:v>1.4781580595076409E-2</c:v>
                </c:pt>
                <c:pt idx="34">
                  <c:v>1.4958679266443332E-2</c:v>
                </c:pt>
                <c:pt idx="35">
                  <c:v>1.5035367322505509E-2</c:v>
                </c:pt>
                <c:pt idx="36">
                  <c:v>1.5284214869883401E-2</c:v>
                </c:pt>
                <c:pt idx="37">
                  <c:v>1.6801923445380222E-2</c:v>
                </c:pt>
                <c:pt idx="38">
                  <c:v>1.7076756630411239E-2</c:v>
                </c:pt>
                <c:pt idx="39">
                  <c:v>1.7980971673558659E-2</c:v>
                </c:pt>
                <c:pt idx="40">
                  <c:v>1.8597527936026315E-2</c:v>
                </c:pt>
                <c:pt idx="41">
                  <c:v>1.88223200985531E-2</c:v>
                </c:pt>
                <c:pt idx="42">
                  <c:v>1.8823149926371619E-2</c:v>
                </c:pt>
                <c:pt idx="43">
                  <c:v>1.9330366008621994E-2</c:v>
                </c:pt>
                <c:pt idx="44">
                  <c:v>1.9434037164263451E-2</c:v>
                </c:pt>
                <c:pt idx="45">
                  <c:v>1.9660843642204912E-2</c:v>
                </c:pt>
                <c:pt idx="46">
                  <c:v>1.985375806612627E-2</c:v>
                </c:pt>
                <c:pt idx="47">
                  <c:v>1.9859677110096421E-2</c:v>
                </c:pt>
                <c:pt idx="48">
                  <c:v>1.9940784815566468E-2</c:v>
                </c:pt>
                <c:pt idx="49">
                  <c:v>2.1252251095455726E-2</c:v>
                </c:pt>
                <c:pt idx="50">
                  <c:v>2.1882809068283632E-2</c:v>
                </c:pt>
                <c:pt idx="51">
                  <c:v>2.3469198008086684E-2</c:v>
                </c:pt>
                <c:pt idx="52">
                  <c:v>2.4096904197069113E-2</c:v>
                </c:pt>
                <c:pt idx="53">
                  <c:v>2.4964815804553484E-2</c:v>
                </c:pt>
                <c:pt idx="54">
                  <c:v>2.5040694035529311E-2</c:v>
                </c:pt>
                <c:pt idx="55">
                  <c:v>2.5416133298432668E-2</c:v>
                </c:pt>
                <c:pt idx="56">
                  <c:v>2.6183815127846666E-2</c:v>
                </c:pt>
                <c:pt idx="57">
                  <c:v>2.721541891033746E-2</c:v>
                </c:pt>
                <c:pt idx="58">
                  <c:v>2.9414110668972152E-2</c:v>
                </c:pt>
                <c:pt idx="59">
                  <c:v>3.0173134285523581E-2</c:v>
                </c:pt>
                <c:pt idx="60">
                  <c:v>3.0678131759599468E-2</c:v>
                </c:pt>
                <c:pt idx="61">
                  <c:v>4.5400222326509941E-2</c:v>
                </c:pt>
                <c:pt idx="62">
                  <c:v>5.0119590160583226E-2</c:v>
                </c:pt>
                <c:pt idx="63">
                  <c:v>5.15460928831647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CC-4B7D-9A2A-3291766B2627}"/>
            </c:ext>
          </c:extLst>
        </c:ser>
        <c:ser>
          <c:idx val="1"/>
          <c:order val="1"/>
          <c:tx>
            <c:strRef>
              <c:f>'Freq HI DSP SSP'!$C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C$4:$C$67</c:f>
              <c:numCache>
                <c:formatCode>General</c:formatCode>
                <c:ptCount val="64"/>
                <c:pt idx="0">
                  <c:v>6.0485815867945564E-4</c:v>
                </c:pt>
                <c:pt idx="1">
                  <c:v>7.9090933564805841E-4</c:v>
                </c:pt>
                <c:pt idx="2">
                  <c:v>8.9097455205406945E-4</c:v>
                </c:pt>
                <c:pt idx="3">
                  <c:v>2.6114674419079596E-3</c:v>
                </c:pt>
                <c:pt idx="4">
                  <c:v>3.8545586990866854E-3</c:v>
                </c:pt>
                <c:pt idx="5">
                  <c:v>3.9809974688976299E-3</c:v>
                </c:pt>
                <c:pt idx="6">
                  <c:v>4.0662386952278829E-3</c:v>
                </c:pt>
                <c:pt idx="7">
                  <c:v>4.7133433557275152E-3</c:v>
                </c:pt>
                <c:pt idx="8">
                  <c:v>4.7839193449708958E-3</c:v>
                </c:pt>
                <c:pt idx="9">
                  <c:v>4.9339362498233086E-3</c:v>
                </c:pt>
                <c:pt idx="10">
                  <c:v>5.2760342946664195E-3</c:v>
                </c:pt>
                <c:pt idx="11">
                  <c:v>5.7515019120697166E-3</c:v>
                </c:pt>
                <c:pt idx="12">
                  <c:v>6.1762152550160453E-3</c:v>
                </c:pt>
                <c:pt idx="13">
                  <c:v>6.5794227203657659E-3</c:v>
                </c:pt>
                <c:pt idx="14">
                  <c:v>6.3413566200722559E-3</c:v>
                </c:pt>
                <c:pt idx="15">
                  <c:v>8.1354327962645853E-3</c:v>
                </c:pt>
                <c:pt idx="16">
                  <c:v>8.1845206074551251E-3</c:v>
                </c:pt>
                <c:pt idx="17">
                  <c:v>8.5609049373563343E-3</c:v>
                </c:pt>
                <c:pt idx="18">
                  <c:v>9.0647331716690403E-3</c:v>
                </c:pt>
                <c:pt idx="19">
                  <c:v>9.529214126390682E-3</c:v>
                </c:pt>
                <c:pt idx="20">
                  <c:v>9.7457839223382501E-3</c:v>
                </c:pt>
                <c:pt idx="21">
                  <c:v>9.8084986906881548E-3</c:v>
                </c:pt>
                <c:pt idx="22">
                  <c:v>1.0123434701736411E-2</c:v>
                </c:pt>
                <c:pt idx="23">
                  <c:v>1.0138151090775854E-2</c:v>
                </c:pt>
                <c:pt idx="24">
                  <c:v>1.0356790235279014E-2</c:v>
                </c:pt>
                <c:pt idx="25">
                  <c:v>1.0832566026507817E-2</c:v>
                </c:pt>
                <c:pt idx="26">
                  <c:v>1.105692937587921E-2</c:v>
                </c:pt>
                <c:pt idx="27">
                  <c:v>1.2156133181663718E-2</c:v>
                </c:pt>
                <c:pt idx="28">
                  <c:v>1.2365753813832677E-2</c:v>
                </c:pt>
                <c:pt idx="29">
                  <c:v>1.2454262715794704E-2</c:v>
                </c:pt>
                <c:pt idx="30">
                  <c:v>1.3922301097788959E-2</c:v>
                </c:pt>
                <c:pt idx="31">
                  <c:v>1.4219938924672725E-2</c:v>
                </c:pt>
                <c:pt idx="32">
                  <c:v>1.4664199103957807E-2</c:v>
                </c:pt>
                <c:pt idx="33">
                  <c:v>1.490048232926763E-2</c:v>
                </c:pt>
                <c:pt idx="34">
                  <c:v>1.5053868260319261E-2</c:v>
                </c:pt>
                <c:pt idx="35">
                  <c:v>1.46097450408183E-2</c:v>
                </c:pt>
                <c:pt idx="36">
                  <c:v>1.5193926342820779E-2</c:v>
                </c:pt>
                <c:pt idx="37">
                  <c:v>1.6918783447681388E-2</c:v>
                </c:pt>
                <c:pt idx="38">
                  <c:v>1.6875534941169335E-2</c:v>
                </c:pt>
                <c:pt idx="39">
                  <c:v>1.8052237719327329E-2</c:v>
                </c:pt>
                <c:pt idx="40">
                  <c:v>1.8476620289247514E-2</c:v>
                </c:pt>
                <c:pt idx="41">
                  <c:v>1.8626400850072708E-2</c:v>
                </c:pt>
                <c:pt idx="42">
                  <c:v>1.882896599090058E-2</c:v>
                </c:pt>
                <c:pt idx="43">
                  <c:v>1.9243569752283907E-2</c:v>
                </c:pt>
                <c:pt idx="44">
                  <c:v>1.9543761527920412E-2</c:v>
                </c:pt>
                <c:pt idx="45">
                  <c:v>1.989227182538637E-2</c:v>
                </c:pt>
                <c:pt idx="46">
                  <c:v>1.9981181594486641E-2</c:v>
                </c:pt>
                <c:pt idx="47">
                  <c:v>1.9975871677531939E-2</c:v>
                </c:pt>
                <c:pt idx="48">
                  <c:v>1.9982184014159462E-2</c:v>
                </c:pt>
                <c:pt idx="49">
                  <c:v>2.1378279426890835E-2</c:v>
                </c:pt>
                <c:pt idx="50">
                  <c:v>2.1782170966953035E-2</c:v>
                </c:pt>
                <c:pt idx="51">
                  <c:v>2.2905299166274515E-2</c:v>
                </c:pt>
                <c:pt idx="52">
                  <c:v>2.425829520353159E-2</c:v>
                </c:pt>
                <c:pt idx="53">
                  <c:v>2.5138755778379318E-2</c:v>
                </c:pt>
                <c:pt idx="54">
                  <c:v>2.5121396832962471E-2</c:v>
                </c:pt>
                <c:pt idx="55">
                  <c:v>2.5503114795515636E-2</c:v>
                </c:pt>
                <c:pt idx="56">
                  <c:v>2.6255633913392695E-2</c:v>
                </c:pt>
                <c:pt idx="57">
                  <c:v>2.7175581680104966E-2</c:v>
                </c:pt>
                <c:pt idx="58">
                  <c:v>2.9320995862483358E-2</c:v>
                </c:pt>
                <c:pt idx="59">
                  <c:v>3.0156065950988218E-2</c:v>
                </c:pt>
                <c:pt idx="60">
                  <c:v>3.0794977204961091E-2</c:v>
                </c:pt>
                <c:pt idx="61">
                  <c:v>4.5501616368423606E-2</c:v>
                </c:pt>
                <c:pt idx="62">
                  <c:v>5.0346838828075162E-2</c:v>
                </c:pt>
                <c:pt idx="63">
                  <c:v>5.15302897934051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CC-4B7D-9A2A-3291766B2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6.0000000000000012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547561728395066"/>
          <c:y val="1.9376092208339479E-2"/>
          <c:w val="0.32693148211154444"/>
          <c:h val="2.20154048458873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 dirty="0"/>
              <a:t>HI: </a:t>
            </a:r>
            <a:r>
              <a:rPr lang="fr-FR" dirty="0"/>
              <a:t>SSP 5' vs SSP 3’</a:t>
            </a:r>
          </a:p>
        </c:rich>
      </c:tx>
      <c:layout>
        <c:manualLayout>
          <c:xMode val="edge"/>
          <c:yMode val="edge"/>
          <c:x val="4.7254740529601054E-2"/>
          <c:y val="1.60247157892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D$3</c:f>
              <c:strCache>
                <c:ptCount val="1"/>
                <c:pt idx="0">
                  <c:v>S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D$4:$D$67</c:f>
              <c:numCache>
                <c:formatCode>General</c:formatCode>
                <c:ptCount val="64"/>
                <c:pt idx="0">
                  <c:v>1.031759903875992E-3</c:v>
                </c:pt>
                <c:pt idx="1">
                  <c:v>2.0516373053169707E-3</c:v>
                </c:pt>
                <c:pt idx="2">
                  <c:v>1.6216281133382042E-3</c:v>
                </c:pt>
                <c:pt idx="3">
                  <c:v>1.0161333791887746E-3</c:v>
                </c:pt>
                <c:pt idx="4">
                  <c:v>2.1678019929803069E-3</c:v>
                </c:pt>
                <c:pt idx="5">
                  <c:v>2.5133927218297376E-3</c:v>
                </c:pt>
                <c:pt idx="6">
                  <c:v>9.5072786086027299E-3</c:v>
                </c:pt>
                <c:pt idx="7">
                  <c:v>2.5532236105255427E-3</c:v>
                </c:pt>
                <c:pt idx="8">
                  <c:v>6.9861828957346918E-3</c:v>
                </c:pt>
                <c:pt idx="9">
                  <c:v>7.6777497924704133E-3</c:v>
                </c:pt>
                <c:pt idx="10">
                  <c:v>1.8432660540710081E-2</c:v>
                </c:pt>
                <c:pt idx="11">
                  <c:v>2.7999586772366968E-3</c:v>
                </c:pt>
                <c:pt idx="12">
                  <c:v>1.1677037771451158E-2</c:v>
                </c:pt>
                <c:pt idx="13">
                  <c:v>1.0168751758189256E-2</c:v>
                </c:pt>
                <c:pt idx="14">
                  <c:v>9.9266910082394678E-3</c:v>
                </c:pt>
                <c:pt idx="15">
                  <c:v>1.9865528284338439E-2</c:v>
                </c:pt>
                <c:pt idx="16">
                  <c:v>1.5861078197914536E-2</c:v>
                </c:pt>
                <c:pt idx="17">
                  <c:v>1.084749096823796E-2</c:v>
                </c:pt>
                <c:pt idx="18">
                  <c:v>1.6554451314333231E-2</c:v>
                </c:pt>
                <c:pt idx="19">
                  <c:v>1.6843249498498171E-2</c:v>
                </c:pt>
                <c:pt idx="20">
                  <c:v>2.4475266376885893E-2</c:v>
                </c:pt>
                <c:pt idx="21">
                  <c:v>2.6026812237227411E-2</c:v>
                </c:pt>
                <c:pt idx="22">
                  <c:v>2.7498741648158073E-2</c:v>
                </c:pt>
                <c:pt idx="23">
                  <c:v>1.8219213681852538E-2</c:v>
                </c:pt>
                <c:pt idx="24">
                  <c:v>1.3554290607611491E-2</c:v>
                </c:pt>
                <c:pt idx="25">
                  <c:v>2.0991104573245503E-2</c:v>
                </c:pt>
                <c:pt idx="26">
                  <c:v>2.1728707498367975E-2</c:v>
                </c:pt>
                <c:pt idx="27">
                  <c:v>1.9188897351632195E-2</c:v>
                </c:pt>
                <c:pt idx="28">
                  <c:v>1.3773095289780744E-2</c:v>
                </c:pt>
                <c:pt idx="29">
                  <c:v>6.1332200256754574E-3</c:v>
                </c:pt>
                <c:pt idx="30">
                  <c:v>1.3525208920583875E-2</c:v>
                </c:pt>
                <c:pt idx="31">
                  <c:v>6.1434021136030133E-3</c:v>
                </c:pt>
                <c:pt idx="32">
                  <c:v>1.5094865937565644E-2</c:v>
                </c:pt>
                <c:pt idx="33">
                  <c:v>2.3370110715931841E-2</c:v>
                </c:pt>
                <c:pt idx="34">
                  <c:v>1.5262761654208271E-2</c:v>
                </c:pt>
                <c:pt idx="35">
                  <c:v>1.0970762615616716E-2</c:v>
                </c:pt>
                <c:pt idx="36">
                  <c:v>1.3927738347541178E-2</c:v>
                </c:pt>
                <c:pt idx="37">
                  <c:v>3.5290251654841578E-2</c:v>
                </c:pt>
                <c:pt idx="38">
                  <c:v>1.2802459792491186E-2</c:v>
                </c:pt>
                <c:pt idx="39">
                  <c:v>1.9652421885443611E-2</c:v>
                </c:pt>
                <c:pt idx="40">
                  <c:v>1.919569903165412E-2</c:v>
                </c:pt>
                <c:pt idx="41">
                  <c:v>8.699062912093684E-3</c:v>
                </c:pt>
                <c:pt idx="42">
                  <c:v>2.1175132538896753E-2</c:v>
                </c:pt>
                <c:pt idx="43">
                  <c:v>2.4523003029700865E-2</c:v>
                </c:pt>
                <c:pt idx="44">
                  <c:v>2.4325384095141116E-2</c:v>
                </c:pt>
                <c:pt idx="45">
                  <c:v>3.2318731624920959E-2</c:v>
                </c:pt>
                <c:pt idx="46">
                  <c:v>2.1728440329786755E-2</c:v>
                </c:pt>
                <c:pt idx="47">
                  <c:v>2.3815838463226418E-2</c:v>
                </c:pt>
                <c:pt idx="48">
                  <c:v>7.6890804388590949E-3</c:v>
                </c:pt>
                <c:pt idx="49">
                  <c:v>2.1850960266621616E-2</c:v>
                </c:pt>
                <c:pt idx="50">
                  <c:v>8.4059269913100056E-3</c:v>
                </c:pt>
                <c:pt idx="51">
                  <c:v>1.5250541767486947E-2</c:v>
                </c:pt>
                <c:pt idx="52">
                  <c:v>1.225875696897176E-2</c:v>
                </c:pt>
                <c:pt idx="53">
                  <c:v>3.4204253939808991E-2</c:v>
                </c:pt>
                <c:pt idx="54">
                  <c:v>9.9252096002656939E-3</c:v>
                </c:pt>
                <c:pt idx="55">
                  <c:v>3.9996141911158668E-2</c:v>
                </c:pt>
                <c:pt idx="56">
                  <c:v>2.1484336463878369E-2</c:v>
                </c:pt>
                <c:pt idx="57">
                  <c:v>2.1962812173272835E-2</c:v>
                </c:pt>
                <c:pt idx="58">
                  <c:v>2.7974451463310963E-2</c:v>
                </c:pt>
                <c:pt idx="59">
                  <c:v>1.0611616463259019E-2</c:v>
                </c:pt>
                <c:pt idx="60">
                  <c:v>2.6859885772914396E-2</c:v>
                </c:pt>
                <c:pt idx="61">
                  <c:v>1.1311893822613378E-2</c:v>
                </c:pt>
                <c:pt idx="62">
                  <c:v>1.3341200861014545E-2</c:v>
                </c:pt>
                <c:pt idx="63">
                  <c:v>1.33586197985564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CB-4C9E-8C1E-445CC17CA95C}"/>
            </c:ext>
          </c:extLst>
        </c:ser>
        <c:ser>
          <c:idx val="1"/>
          <c:order val="1"/>
          <c:tx>
            <c:strRef>
              <c:f>'Freq HI DSP SSP'!$E$3</c:f>
              <c:strCache>
                <c:ptCount val="1"/>
                <c:pt idx="0">
                  <c:v>S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E$4:$E$67</c:f>
              <c:numCache>
                <c:formatCode>General</c:formatCode>
                <c:ptCount val="64"/>
                <c:pt idx="0">
                  <c:v>1.00940080521349E-3</c:v>
                </c:pt>
                <c:pt idx="1">
                  <c:v>2.081717441789616E-3</c:v>
                </c:pt>
                <c:pt idx="2">
                  <c:v>1.6444286612152463E-3</c:v>
                </c:pt>
                <c:pt idx="3">
                  <c:v>1.0172429067202046E-3</c:v>
                </c:pt>
                <c:pt idx="4">
                  <c:v>2.1695088957972715E-3</c:v>
                </c:pt>
                <c:pt idx="5">
                  <c:v>2.5343410487256844E-3</c:v>
                </c:pt>
                <c:pt idx="6">
                  <c:v>9.4638974111939406E-3</c:v>
                </c:pt>
                <c:pt idx="7">
                  <c:v>2.5569834349536565E-3</c:v>
                </c:pt>
                <c:pt idx="8">
                  <c:v>7.0334653767274878E-3</c:v>
                </c:pt>
                <c:pt idx="9">
                  <c:v>7.4144703333225139E-3</c:v>
                </c:pt>
                <c:pt idx="10">
                  <c:v>1.870453507748164E-2</c:v>
                </c:pt>
                <c:pt idx="11">
                  <c:v>2.8227704544536323E-3</c:v>
                </c:pt>
                <c:pt idx="12">
                  <c:v>1.1744780683584559E-2</c:v>
                </c:pt>
                <c:pt idx="13">
                  <c:v>1.0230936775328305E-2</c:v>
                </c:pt>
                <c:pt idx="14">
                  <c:v>9.5471492726674437E-3</c:v>
                </c:pt>
                <c:pt idx="15">
                  <c:v>2.0101831720630257E-2</c:v>
                </c:pt>
                <c:pt idx="16">
                  <c:v>1.5991836893671337E-2</c:v>
                </c:pt>
                <c:pt idx="17">
                  <c:v>1.0353864416701339E-2</c:v>
                </c:pt>
                <c:pt idx="18">
                  <c:v>1.6690199698662946E-2</c:v>
                </c:pt>
                <c:pt idx="19">
                  <c:v>1.6979101752257163E-2</c:v>
                </c:pt>
                <c:pt idx="20">
                  <c:v>2.4723124665688177E-2</c:v>
                </c:pt>
                <c:pt idx="21">
                  <c:v>2.6289071514506115E-2</c:v>
                </c:pt>
                <c:pt idx="22">
                  <c:v>2.785764605618124E-2</c:v>
                </c:pt>
                <c:pt idx="23">
                  <c:v>1.840196392999955E-2</c:v>
                </c:pt>
                <c:pt idx="24">
                  <c:v>1.3696904879583093E-2</c:v>
                </c:pt>
                <c:pt idx="25">
                  <c:v>2.1053104321885702E-2</c:v>
                </c:pt>
                <c:pt idx="26">
                  <c:v>2.2089074889340199E-2</c:v>
                </c:pt>
                <c:pt idx="27">
                  <c:v>1.9405402697152418E-2</c:v>
                </c:pt>
                <c:pt idx="28">
                  <c:v>1.3688966575347881E-2</c:v>
                </c:pt>
                <c:pt idx="29">
                  <c:v>5.9998313313307673E-3</c:v>
                </c:pt>
                <c:pt idx="30">
                  <c:v>1.3633494268421826E-2</c:v>
                </c:pt>
                <c:pt idx="31">
                  <c:v>5.8776120395907508E-3</c:v>
                </c:pt>
                <c:pt idx="32">
                  <c:v>1.4785347216594063E-2</c:v>
                </c:pt>
                <c:pt idx="33">
                  <c:v>2.3551147850291786E-2</c:v>
                </c:pt>
                <c:pt idx="34">
                  <c:v>1.539191716000067E-2</c:v>
                </c:pt>
                <c:pt idx="35">
                  <c:v>1.082616168462408E-2</c:v>
                </c:pt>
                <c:pt idx="36">
                  <c:v>1.3817519912225218E-2</c:v>
                </c:pt>
                <c:pt idx="37">
                  <c:v>3.5728316216604383E-2</c:v>
                </c:pt>
                <c:pt idx="38">
                  <c:v>1.275240770377763E-2</c:v>
                </c:pt>
                <c:pt idx="39">
                  <c:v>1.9773591227677367E-2</c:v>
                </c:pt>
                <c:pt idx="40">
                  <c:v>1.8795184716141798E-2</c:v>
                </c:pt>
                <c:pt idx="41">
                  <c:v>7.7523966632983884E-3</c:v>
                </c:pt>
                <c:pt idx="42">
                  <c:v>2.1277245861937161E-2</c:v>
                </c:pt>
                <c:pt idx="43">
                  <c:v>2.4085583910538194E-2</c:v>
                </c:pt>
                <c:pt idx="44">
                  <c:v>2.4494684598635848E-2</c:v>
                </c:pt>
                <c:pt idx="45">
                  <c:v>3.2819441118613187E-2</c:v>
                </c:pt>
                <c:pt idx="46">
                  <c:v>2.1852478951142978E-2</c:v>
                </c:pt>
                <c:pt idx="47">
                  <c:v>2.4012621933397163E-2</c:v>
                </c:pt>
                <c:pt idx="48">
                  <c:v>7.718767193074706E-3</c:v>
                </c:pt>
                <c:pt idx="49">
                  <c:v>2.1969436261173248E-2</c:v>
                </c:pt>
                <c:pt idx="50">
                  <c:v>8.0396524479137681E-3</c:v>
                </c:pt>
                <c:pt idx="51">
                  <c:v>1.4581805186592476E-2</c:v>
                </c:pt>
                <c:pt idx="52">
                  <c:v>1.2324202051662509E-2</c:v>
                </c:pt>
                <c:pt idx="53">
                  <c:v>3.4597504008359092E-2</c:v>
                </c:pt>
                <c:pt idx="54">
                  <c:v>9.9121521162734844E-3</c:v>
                </c:pt>
                <c:pt idx="55">
                  <c:v>4.0318575478691734E-2</c:v>
                </c:pt>
                <c:pt idx="56">
                  <c:v>2.1416165965436291E-2</c:v>
                </c:pt>
                <c:pt idx="57">
                  <c:v>2.1714731416867278E-2</c:v>
                </c:pt>
                <c:pt idx="58">
                  <c:v>2.7502943272622017E-2</c:v>
                </c:pt>
                <c:pt idx="59">
                  <c:v>1.0527302921504191E-2</c:v>
                </c:pt>
                <c:pt idx="60">
                  <c:v>2.6731775773542635E-2</c:v>
                </c:pt>
                <c:pt idx="61">
                  <c:v>1.1379933296599158E-2</c:v>
                </c:pt>
                <c:pt idx="62">
                  <c:v>1.3391299985858789E-2</c:v>
                </c:pt>
                <c:pt idx="63">
                  <c:v>1.33490456682032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9CB-4C9E-8C1E-445CC17CA9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5.5000000000000007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203584466872877"/>
          <c:y val="1.9124690565082647E-2"/>
          <c:w val="0.32693148211154444"/>
          <c:h val="2.20154048458873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mCRC</a:t>
            </a:r>
            <a:r>
              <a:rPr lang="fr-FR"/>
              <a:t>: SSP 5' vs SSP 3'</a:t>
            </a:r>
          </a:p>
        </c:rich>
      </c:tx>
      <c:layout>
        <c:manualLayout>
          <c:xMode val="edge"/>
          <c:yMode val="edge"/>
          <c:x val="8.787743807876898E-2"/>
          <c:y val="9.521618465213639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AU$3</c:f>
              <c:strCache>
                <c:ptCount val="1"/>
                <c:pt idx="0">
                  <c:v>S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U$4:$AU$67</c:f>
              <c:numCache>
                <c:formatCode>General</c:formatCode>
                <c:ptCount val="64"/>
                <c:pt idx="0">
                  <c:v>1.1708624653753385E-3</c:v>
                </c:pt>
                <c:pt idx="1">
                  <c:v>2.1856709012487057E-3</c:v>
                </c:pt>
                <c:pt idx="2">
                  <c:v>1.7024410159432353E-3</c:v>
                </c:pt>
                <c:pt idx="3">
                  <c:v>1.2380341511327956E-3</c:v>
                </c:pt>
                <c:pt idx="4">
                  <c:v>2.0688948279347081E-3</c:v>
                </c:pt>
                <c:pt idx="5">
                  <c:v>2.4167549641408931E-3</c:v>
                </c:pt>
                <c:pt idx="6">
                  <c:v>1.0287571984399077E-2</c:v>
                </c:pt>
                <c:pt idx="7">
                  <c:v>2.4463744084479316E-3</c:v>
                </c:pt>
                <c:pt idx="8">
                  <c:v>7.7959956517566469E-3</c:v>
                </c:pt>
                <c:pt idx="9">
                  <c:v>9.2557636158234861E-3</c:v>
                </c:pt>
                <c:pt idx="10">
                  <c:v>1.9036437927387354E-2</c:v>
                </c:pt>
                <c:pt idx="11">
                  <c:v>2.6298734307367896E-3</c:v>
                </c:pt>
                <c:pt idx="12">
                  <c:v>1.2798469556950501E-2</c:v>
                </c:pt>
                <c:pt idx="13">
                  <c:v>1.093070833168127E-2</c:v>
                </c:pt>
                <c:pt idx="14">
                  <c:v>1.1365899990486436E-2</c:v>
                </c:pt>
                <c:pt idx="15">
                  <c:v>1.9736078962638282E-2</c:v>
                </c:pt>
                <c:pt idx="16">
                  <c:v>1.6760085465544826E-2</c:v>
                </c:pt>
                <c:pt idx="17">
                  <c:v>1.2566042640707481E-2</c:v>
                </c:pt>
                <c:pt idx="18">
                  <c:v>1.6256839759456725E-2</c:v>
                </c:pt>
                <c:pt idx="19">
                  <c:v>1.603857411795272E-2</c:v>
                </c:pt>
                <c:pt idx="20">
                  <c:v>2.3648054541405308E-2</c:v>
                </c:pt>
                <c:pt idx="21">
                  <c:v>2.4686080296445995E-2</c:v>
                </c:pt>
                <c:pt idx="22">
                  <c:v>2.6096938423310394E-2</c:v>
                </c:pt>
                <c:pt idx="23">
                  <c:v>1.7864108750969835E-2</c:v>
                </c:pt>
                <c:pt idx="24">
                  <c:v>1.4269274366584586E-2</c:v>
                </c:pt>
                <c:pt idx="25">
                  <c:v>2.0880718831179736E-2</c:v>
                </c:pt>
                <c:pt idx="26">
                  <c:v>2.2481581377565299E-2</c:v>
                </c:pt>
                <c:pt idx="27">
                  <c:v>1.9633691482187472E-2</c:v>
                </c:pt>
                <c:pt idx="28">
                  <c:v>1.366233629103045E-2</c:v>
                </c:pt>
                <c:pt idx="29">
                  <c:v>7.2179738972226364E-3</c:v>
                </c:pt>
                <c:pt idx="30">
                  <c:v>1.2538594103995059E-2</c:v>
                </c:pt>
                <c:pt idx="31">
                  <c:v>7.1150638201419297E-3</c:v>
                </c:pt>
                <c:pt idx="32">
                  <c:v>1.7439126770496537E-2</c:v>
                </c:pt>
                <c:pt idx="33">
                  <c:v>2.0970495420331817E-2</c:v>
                </c:pt>
                <c:pt idx="34">
                  <c:v>1.4857055418331317E-2</c:v>
                </c:pt>
                <c:pt idx="35">
                  <c:v>1.0446724072462167E-2</c:v>
                </c:pt>
                <c:pt idx="36">
                  <c:v>1.4001127452596426E-2</c:v>
                </c:pt>
                <c:pt idx="37">
                  <c:v>3.4735654729638597E-2</c:v>
                </c:pt>
                <c:pt idx="38">
                  <c:v>1.252720261528702E-2</c:v>
                </c:pt>
                <c:pt idx="39">
                  <c:v>1.7834699999856814E-2</c:v>
                </c:pt>
                <c:pt idx="40">
                  <c:v>1.9077676016648761E-2</c:v>
                </c:pt>
                <c:pt idx="41">
                  <c:v>1.1269408364875109E-2</c:v>
                </c:pt>
                <c:pt idx="42">
                  <c:v>2.0331959811006276E-2</c:v>
                </c:pt>
                <c:pt idx="43">
                  <c:v>2.3797429679653485E-2</c:v>
                </c:pt>
                <c:pt idx="44">
                  <c:v>2.1384692427595144E-2</c:v>
                </c:pt>
                <c:pt idx="45">
                  <c:v>3.2656596467029973E-2</c:v>
                </c:pt>
                <c:pt idx="46">
                  <c:v>1.9650121003653213E-2</c:v>
                </c:pt>
                <c:pt idx="47">
                  <c:v>2.1727347367209941E-2</c:v>
                </c:pt>
                <c:pt idx="48">
                  <c:v>8.089816604964814E-3</c:v>
                </c:pt>
                <c:pt idx="49">
                  <c:v>1.8490421809010442E-2</c:v>
                </c:pt>
                <c:pt idx="50">
                  <c:v>1.0275969348757401E-2</c:v>
                </c:pt>
                <c:pt idx="51">
                  <c:v>1.5693984767913186E-2</c:v>
                </c:pt>
                <c:pt idx="52">
                  <c:v>1.2951964799886029E-2</c:v>
                </c:pt>
                <c:pt idx="53">
                  <c:v>3.1086456220947471E-2</c:v>
                </c:pt>
                <c:pt idx="54">
                  <c:v>1.1118987465903474E-2</c:v>
                </c:pt>
                <c:pt idx="55">
                  <c:v>4.1503186568829981E-2</c:v>
                </c:pt>
                <c:pt idx="56">
                  <c:v>2.2289815951291519E-2</c:v>
                </c:pt>
                <c:pt idx="57">
                  <c:v>2.3798416978773242E-2</c:v>
                </c:pt>
                <c:pt idx="58">
                  <c:v>2.8345726436647019E-2</c:v>
                </c:pt>
                <c:pt idx="59">
                  <c:v>1.1875937590516394E-2</c:v>
                </c:pt>
                <c:pt idx="60">
                  <c:v>2.7232638370220368E-2</c:v>
                </c:pt>
                <c:pt idx="61">
                  <c:v>1.0055248465641091E-2</c:v>
                </c:pt>
                <c:pt idx="62">
                  <c:v>1.260279650814785E-2</c:v>
                </c:pt>
                <c:pt idx="63">
                  <c:v>1.309952414409325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D9-42FD-BEE4-AF593C602980}"/>
            </c:ext>
          </c:extLst>
        </c:ser>
        <c:ser>
          <c:idx val="1"/>
          <c:order val="1"/>
          <c:tx>
            <c:strRef>
              <c:f>'Freq HI DSP SSP'!$AV$3</c:f>
              <c:strCache>
                <c:ptCount val="1"/>
                <c:pt idx="0">
                  <c:v>S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V$4:$AV$67</c:f>
              <c:numCache>
                <c:formatCode>General</c:formatCode>
                <c:ptCount val="64"/>
                <c:pt idx="0">
                  <c:v>1.0945887920592442E-3</c:v>
                </c:pt>
                <c:pt idx="1">
                  <c:v>2.2409066946741806E-3</c:v>
                </c:pt>
                <c:pt idx="2">
                  <c:v>1.7301651873302423E-3</c:v>
                </c:pt>
                <c:pt idx="3">
                  <c:v>1.2450348339000548E-3</c:v>
                </c:pt>
                <c:pt idx="4">
                  <c:v>2.0934409700273738E-3</c:v>
                </c:pt>
                <c:pt idx="5">
                  <c:v>2.4692983644430864E-3</c:v>
                </c:pt>
                <c:pt idx="6">
                  <c:v>1.0182415284715455E-2</c:v>
                </c:pt>
                <c:pt idx="7">
                  <c:v>2.453486666927766E-3</c:v>
                </c:pt>
                <c:pt idx="8">
                  <c:v>7.8845491675998639E-3</c:v>
                </c:pt>
                <c:pt idx="9">
                  <c:v>8.6868704433793655E-3</c:v>
                </c:pt>
                <c:pt idx="10">
                  <c:v>1.9609161356254456E-2</c:v>
                </c:pt>
                <c:pt idx="11">
                  <c:v>2.6796023351708192E-3</c:v>
                </c:pt>
                <c:pt idx="12">
                  <c:v>1.294359326574286E-2</c:v>
                </c:pt>
                <c:pt idx="13">
                  <c:v>1.1053985659588435E-2</c:v>
                </c:pt>
                <c:pt idx="14">
                  <c:v>1.0279300671277603E-2</c:v>
                </c:pt>
                <c:pt idx="15">
                  <c:v>2.0151690089787774E-2</c:v>
                </c:pt>
                <c:pt idx="16">
                  <c:v>1.7055865399011719E-2</c:v>
                </c:pt>
                <c:pt idx="17">
                  <c:v>1.1143314596004946E-2</c:v>
                </c:pt>
                <c:pt idx="18">
                  <c:v>1.6605599627582537E-2</c:v>
                </c:pt>
                <c:pt idx="19">
                  <c:v>1.6342037681605769E-2</c:v>
                </c:pt>
                <c:pt idx="20">
                  <c:v>2.425820816814285E-2</c:v>
                </c:pt>
                <c:pt idx="21">
                  <c:v>2.5276570450914707E-2</c:v>
                </c:pt>
                <c:pt idx="22">
                  <c:v>2.6848162108710091E-2</c:v>
                </c:pt>
                <c:pt idx="23">
                  <c:v>1.830991011553874E-2</c:v>
                </c:pt>
                <c:pt idx="24">
                  <c:v>1.4523900987058793E-2</c:v>
                </c:pt>
                <c:pt idx="25">
                  <c:v>2.118375292010348E-2</c:v>
                </c:pt>
                <c:pt idx="26">
                  <c:v>2.3273517221464073E-2</c:v>
                </c:pt>
                <c:pt idx="27">
                  <c:v>2.016488637460025E-2</c:v>
                </c:pt>
                <c:pt idx="28">
                  <c:v>1.3406169741426315E-2</c:v>
                </c:pt>
                <c:pt idx="29">
                  <c:v>6.9399557112220173E-3</c:v>
                </c:pt>
                <c:pt idx="30">
                  <c:v>1.278692581993412E-2</c:v>
                </c:pt>
                <c:pt idx="31">
                  <c:v>6.5047539405674558E-3</c:v>
                </c:pt>
                <c:pt idx="32">
                  <c:v>1.6691627895167545E-2</c:v>
                </c:pt>
                <c:pt idx="33">
                  <c:v>2.1404294370526791E-2</c:v>
                </c:pt>
                <c:pt idx="34">
                  <c:v>1.5128140627774787E-2</c:v>
                </c:pt>
                <c:pt idx="35">
                  <c:v>1.0281125672483266E-2</c:v>
                </c:pt>
                <c:pt idx="36">
                  <c:v>1.3916604717085782E-2</c:v>
                </c:pt>
                <c:pt idx="37">
                  <c:v>3.5673414374386279E-2</c:v>
                </c:pt>
                <c:pt idx="38">
                  <c:v>1.2377306106860953E-2</c:v>
                </c:pt>
                <c:pt idx="39">
                  <c:v>1.8109316347016131E-2</c:v>
                </c:pt>
                <c:pt idx="40">
                  <c:v>1.8444209451739239E-2</c:v>
                </c:pt>
                <c:pt idx="41">
                  <c:v>9.3180144249296656E-3</c:v>
                </c:pt>
                <c:pt idx="42">
                  <c:v>2.0716058566623109E-2</c:v>
                </c:pt>
                <c:pt idx="43">
                  <c:v>2.3000057025766765E-2</c:v>
                </c:pt>
                <c:pt idx="44">
                  <c:v>2.1731790590543233E-2</c:v>
                </c:pt>
                <c:pt idx="45">
                  <c:v>3.3611711245576402E-2</c:v>
                </c:pt>
                <c:pt idx="46">
                  <c:v>1.9973284516907094E-2</c:v>
                </c:pt>
                <c:pt idx="47">
                  <c:v>2.2157071788892212E-2</c:v>
                </c:pt>
                <c:pt idx="48">
                  <c:v>8.1843107770669596E-3</c:v>
                </c:pt>
                <c:pt idx="49">
                  <c:v>1.8750251732391605E-2</c:v>
                </c:pt>
                <c:pt idx="50">
                  <c:v>9.0610848725463967E-3</c:v>
                </c:pt>
                <c:pt idx="51">
                  <c:v>1.4092709709528601E-2</c:v>
                </c:pt>
                <c:pt idx="52">
                  <c:v>1.3035104615850003E-2</c:v>
                </c:pt>
                <c:pt idx="53">
                  <c:v>3.1677415558334296E-2</c:v>
                </c:pt>
                <c:pt idx="54">
                  <c:v>1.117352137881731E-2</c:v>
                </c:pt>
                <c:pt idx="55">
                  <c:v>4.2313642667990287E-2</c:v>
                </c:pt>
                <c:pt idx="56">
                  <c:v>2.2247818992847505E-2</c:v>
                </c:pt>
                <c:pt idx="57">
                  <c:v>2.3322130156142467E-2</c:v>
                </c:pt>
                <c:pt idx="58">
                  <c:v>2.7359521822232467E-2</c:v>
                </c:pt>
                <c:pt idx="59">
                  <c:v>1.1820625195415869E-2</c:v>
                </c:pt>
                <c:pt idx="60">
                  <c:v>2.6994055138925575E-2</c:v>
                </c:pt>
                <c:pt idx="61">
                  <c:v>1.0165488543163232E-2</c:v>
                </c:pt>
                <c:pt idx="62">
                  <c:v>1.272147209025231E-2</c:v>
                </c:pt>
                <c:pt idx="63">
                  <c:v>1.312519837944942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6D9-42FD-BEE4-AF593C6029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5.5000000000000007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684438543227439"/>
          <c:y val="1.3862683909685789E-2"/>
          <c:w val="0.32693148211154444"/>
          <c:h val="2.20154048458873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b="1">
                <a:solidFill>
                  <a:schemeClr val="tx1"/>
                </a:solidFill>
              </a:rPr>
              <a:t>mCRC:</a:t>
            </a:r>
            <a:r>
              <a:rPr lang="fr-FR">
                <a:solidFill>
                  <a:schemeClr val="tx1"/>
                </a:solidFill>
              </a:rPr>
              <a:t> DSP 5' vs DSP 3'</a:t>
            </a:r>
          </a:p>
        </c:rich>
      </c:tx>
      <c:layout>
        <c:manualLayout>
          <c:xMode val="edge"/>
          <c:yMode val="edge"/>
          <c:x val="9.1053861433943256E-2"/>
          <c:y val="1.49625433024785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2043931296152748"/>
          <c:y val="5.3447645391631438E-2"/>
          <c:w val="0.79150879197095181"/>
          <c:h val="0.9211719343465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Freq HI DSP SSP'!$AS$3</c:f>
              <c:strCache>
                <c:ptCount val="1"/>
                <c:pt idx="0">
                  <c:v>DSP 5'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S$4:$AS$67</c:f>
              <c:numCache>
                <c:formatCode>General</c:formatCode>
                <c:ptCount val="64"/>
                <c:pt idx="0">
                  <c:v>1.1256999043050672E-3</c:v>
                </c:pt>
                <c:pt idx="1">
                  <c:v>9.9542959805862209E-4</c:v>
                </c:pt>
                <c:pt idx="2">
                  <c:v>9.6007028509582915E-4</c:v>
                </c:pt>
                <c:pt idx="3">
                  <c:v>2.7493148784668089E-3</c:v>
                </c:pt>
                <c:pt idx="4">
                  <c:v>3.3945989205330517E-3</c:v>
                </c:pt>
                <c:pt idx="5">
                  <c:v>3.58318174112614E-3</c:v>
                </c:pt>
                <c:pt idx="6">
                  <c:v>5.5770329186657121E-3</c:v>
                </c:pt>
                <c:pt idx="7">
                  <c:v>4.1802546244154564E-3</c:v>
                </c:pt>
                <c:pt idx="8">
                  <c:v>5.2603846607363969E-3</c:v>
                </c:pt>
                <c:pt idx="9">
                  <c:v>8.9032254019188965E-3</c:v>
                </c:pt>
                <c:pt idx="10">
                  <c:v>6.9006205274980978E-3</c:v>
                </c:pt>
                <c:pt idx="11">
                  <c:v>4.6003942757685701E-3</c:v>
                </c:pt>
                <c:pt idx="12">
                  <c:v>7.1376917761548841E-3</c:v>
                </c:pt>
                <c:pt idx="13">
                  <c:v>7.172205056879712E-3</c:v>
                </c:pt>
                <c:pt idx="14">
                  <c:v>1.0259129286687227E-2</c:v>
                </c:pt>
                <c:pt idx="15">
                  <c:v>9.8622815739332331E-3</c:v>
                </c:pt>
                <c:pt idx="16">
                  <c:v>9.1919944313690223E-3</c:v>
                </c:pt>
                <c:pt idx="17">
                  <c:v>1.3619553333906092E-2</c:v>
                </c:pt>
                <c:pt idx="18">
                  <c:v>9.1480241929721342E-3</c:v>
                </c:pt>
                <c:pt idx="19">
                  <c:v>8.6207150550853227E-3</c:v>
                </c:pt>
                <c:pt idx="20">
                  <c:v>1.1146501351790964E-2</c:v>
                </c:pt>
                <c:pt idx="21">
                  <c:v>1.0157698713995873E-2</c:v>
                </c:pt>
                <c:pt idx="22">
                  <c:v>1.141040120907227E-2</c:v>
                </c:pt>
                <c:pt idx="23">
                  <c:v>9.8310126950799503E-3</c:v>
                </c:pt>
                <c:pt idx="24">
                  <c:v>1.0265295788024211E-2</c:v>
                </c:pt>
                <c:pt idx="25">
                  <c:v>1.058420859168881E-2</c:v>
                </c:pt>
                <c:pt idx="26">
                  <c:v>1.1620074159697064E-2</c:v>
                </c:pt>
                <c:pt idx="27">
                  <c:v>1.1800074067085919E-2</c:v>
                </c:pt>
                <c:pt idx="28">
                  <c:v>1.4311864004502141E-2</c:v>
                </c:pt>
                <c:pt idx="29">
                  <c:v>1.6246002019670365E-2</c:v>
                </c:pt>
                <c:pt idx="30">
                  <c:v>1.1597197058503131E-2</c:v>
                </c:pt>
                <c:pt idx="31">
                  <c:v>1.576392284130633E-2</c:v>
                </c:pt>
                <c:pt idx="32">
                  <c:v>1.7944035050930288E-2</c:v>
                </c:pt>
                <c:pt idx="33">
                  <c:v>1.2638645985096141E-2</c:v>
                </c:pt>
                <c:pt idx="34">
                  <c:v>1.2886224815185284E-2</c:v>
                </c:pt>
                <c:pt idx="35">
                  <c:v>1.626781690214979E-2</c:v>
                </c:pt>
                <c:pt idx="36">
                  <c:v>1.5979194547977374E-2</c:v>
                </c:pt>
                <c:pt idx="37">
                  <c:v>1.8190737488535835E-2</c:v>
                </c:pt>
                <c:pt idx="38">
                  <c:v>1.9209072504042819E-2</c:v>
                </c:pt>
                <c:pt idx="39">
                  <c:v>1.4987658269353301E-2</c:v>
                </c:pt>
                <c:pt idx="40">
                  <c:v>1.959285029447478E-2</c:v>
                </c:pt>
                <c:pt idx="41">
                  <c:v>2.1697126288823702E-2</c:v>
                </c:pt>
                <c:pt idx="42">
                  <c:v>1.6795664663149811E-2</c:v>
                </c:pt>
                <c:pt idx="43">
                  <c:v>2.2328799646573767E-2</c:v>
                </c:pt>
                <c:pt idx="44">
                  <c:v>1.5874073766366379E-2</c:v>
                </c:pt>
                <c:pt idx="45">
                  <c:v>2.0383680642539401E-2</c:v>
                </c:pt>
                <c:pt idx="46">
                  <c:v>1.6236613695790134E-2</c:v>
                </c:pt>
                <c:pt idx="47">
                  <c:v>1.6411763717905339E-2</c:v>
                </c:pt>
                <c:pt idx="48">
                  <c:v>1.9251519869822552E-2</c:v>
                </c:pt>
                <c:pt idx="49">
                  <c:v>1.6843846867180788E-2</c:v>
                </c:pt>
                <c:pt idx="50">
                  <c:v>2.3523904514467089E-2</c:v>
                </c:pt>
                <c:pt idx="51">
                  <c:v>2.5964960608284435E-2</c:v>
                </c:pt>
                <c:pt idx="52">
                  <c:v>2.4682696858417199E-2</c:v>
                </c:pt>
                <c:pt idx="53">
                  <c:v>2.1906918989053059E-2</c:v>
                </c:pt>
                <c:pt idx="54">
                  <c:v>2.4100931963105969E-2</c:v>
                </c:pt>
                <c:pt idx="55">
                  <c:v>2.8236153620380382E-2</c:v>
                </c:pt>
                <c:pt idx="56">
                  <c:v>2.7096312919638824E-2</c:v>
                </c:pt>
                <c:pt idx="57">
                  <c:v>3.1746992692008917E-2</c:v>
                </c:pt>
                <c:pt idx="58">
                  <c:v>3.2782953438999361E-2</c:v>
                </c:pt>
                <c:pt idx="59">
                  <c:v>3.0971616358383084E-2</c:v>
                </c:pt>
                <c:pt idx="60">
                  <c:v>3.041782136363921E-2</c:v>
                </c:pt>
                <c:pt idx="61">
                  <c:v>3.5331354065567776E-2</c:v>
                </c:pt>
                <c:pt idx="62">
                  <c:v>3.9637972283234749E-2</c:v>
                </c:pt>
                <c:pt idx="63">
                  <c:v>4.2104030364929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B4-40D3-8EF8-562B3369A7D9}"/>
            </c:ext>
          </c:extLst>
        </c:ser>
        <c:ser>
          <c:idx val="1"/>
          <c:order val="1"/>
          <c:tx>
            <c:strRef>
              <c:f>'Freq HI DSP SSP'!$AT$3</c:f>
              <c:strCache>
                <c:ptCount val="1"/>
                <c:pt idx="0">
                  <c:v>DSP 3'</c:v>
                </c:pt>
              </c:strCache>
            </c:strRef>
          </c:tx>
          <c:spPr>
            <a:solidFill>
              <a:srgbClr val="EF41BD"/>
            </a:solidFill>
            <a:ln>
              <a:noFill/>
            </a:ln>
            <a:effectLst/>
          </c:spPr>
          <c:invertIfNegative val="0"/>
          <c:cat>
            <c:strRef>
              <c:f>'Freq HI DSP SSP'!$A$4:$A$67</c:f>
              <c:strCache>
                <c:ptCount val="64"/>
                <c:pt idx="0">
                  <c:v>TCG</c:v>
                </c:pt>
                <c:pt idx="1">
                  <c:v>ACG</c:v>
                </c:pt>
                <c:pt idx="2">
                  <c:v>GCG</c:v>
                </c:pt>
                <c:pt idx="3">
                  <c:v>CCG</c:v>
                </c:pt>
                <c:pt idx="4">
                  <c:v>CGC</c:v>
                </c:pt>
                <c:pt idx="5">
                  <c:v>CGG</c:v>
                </c:pt>
                <c:pt idx="6">
                  <c:v>ATC</c:v>
                </c:pt>
                <c:pt idx="7">
                  <c:v>CGA</c:v>
                </c:pt>
                <c:pt idx="8">
                  <c:v>GTC</c:v>
                </c:pt>
                <c:pt idx="9">
                  <c:v>TTC</c:v>
                </c:pt>
                <c:pt idx="10">
                  <c:v>ATG</c:v>
                </c:pt>
                <c:pt idx="11">
                  <c:v>CGT</c:v>
                </c:pt>
                <c:pt idx="12">
                  <c:v>GTG</c:v>
                </c:pt>
                <c:pt idx="13">
                  <c:v>GTA</c:v>
                </c:pt>
                <c:pt idx="14">
                  <c:v>TTG</c:v>
                </c:pt>
                <c:pt idx="15">
                  <c:v>ATA</c:v>
                </c:pt>
                <c:pt idx="16">
                  <c:v>ATT</c:v>
                </c:pt>
                <c:pt idx="17">
                  <c:v>TTA</c:v>
                </c:pt>
                <c:pt idx="18">
                  <c:v>AAC</c:v>
                </c:pt>
                <c:pt idx="19">
                  <c:v>GAC</c:v>
                </c:pt>
                <c:pt idx="20">
                  <c:v>AAG</c:v>
                </c:pt>
                <c:pt idx="21">
                  <c:v>GAG</c:v>
                </c:pt>
                <c:pt idx="22">
                  <c:v>AGG</c:v>
                </c:pt>
                <c:pt idx="23">
                  <c:v>AGC</c:v>
                </c:pt>
                <c:pt idx="24">
                  <c:v>GTT</c:v>
                </c:pt>
                <c:pt idx="25">
                  <c:v>GAT</c:v>
                </c:pt>
                <c:pt idx="26">
                  <c:v>AAT</c:v>
                </c:pt>
                <c:pt idx="27">
                  <c:v>AGT</c:v>
                </c:pt>
                <c:pt idx="28">
                  <c:v>TAG</c:v>
                </c:pt>
                <c:pt idx="29">
                  <c:v>CTC</c:v>
                </c:pt>
                <c:pt idx="30">
                  <c:v>ACC</c:v>
                </c:pt>
                <c:pt idx="31">
                  <c:v>CTA</c:v>
                </c:pt>
                <c:pt idx="32">
                  <c:v>TTT</c:v>
                </c:pt>
                <c:pt idx="33">
                  <c:v>GGG</c:v>
                </c:pt>
                <c:pt idx="34">
                  <c:v>ACT</c:v>
                </c:pt>
                <c:pt idx="35">
                  <c:v>TCC</c:v>
                </c:pt>
                <c:pt idx="36">
                  <c:v>TAC</c:v>
                </c:pt>
                <c:pt idx="37">
                  <c:v>AGA</c:v>
                </c:pt>
                <c:pt idx="38">
                  <c:v>TCA</c:v>
                </c:pt>
                <c:pt idx="39">
                  <c:v>GCA</c:v>
                </c:pt>
                <c:pt idx="40">
                  <c:v>TGC</c:v>
                </c:pt>
                <c:pt idx="41">
                  <c:v>CTG</c:v>
                </c:pt>
                <c:pt idx="42">
                  <c:v>ACA</c:v>
                </c:pt>
                <c:pt idx="43">
                  <c:v>TGG</c:v>
                </c:pt>
                <c:pt idx="44">
                  <c:v>GGC</c:v>
                </c:pt>
                <c:pt idx="45">
                  <c:v>GAA</c:v>
                </c:pt>
                <c:pt idx="46">
                  <c:v>GCT</c:v>
                </c:pt>
                <c:pt idx="47">
                  <c:v>GGT</c:v>
                </c:pt>
                <c:pt idx="48">
                  <c:v>CAC</c:v>
                </c:pt>
                <c:pt idx="49">
                  <c:v>GCC</c:v>
                </c:pt>
                <c:pt idx="50">
                  <c:v>CTT</c:v>
                </c:pt>
                <c:pt idx="51">
                  <c:v>TCT</c:v>
                </c:pt>
                <c:pt idx="52">
                  <c:v>CAG</c:v>
                </c:pt>
                <c:pt idx="53">
                  <c:v>GGA</c:v>
                </c:pt>
                <c:pt idx="54">
                  <c:v>CAT</c:v>
                </c:pt>
                <c:pt idx="55">
                  <c:v>AAA</c:v>
                </c:pt>
                <c:pt idx="56">
                  <c:v>TAT</c:v>
                </c:pt>
                <c:pt idx="57">
                  <c:v>TAA</c:v>
                </c:pt>
                <c:pt idx="58">
                  <c:v>TGA</c:v>
                </c:pt>
                <c:pt idx="59">
                  <c:v>CAA</c:v>
                </c:pt>
                <c:pt idx="60">
                  <c:v>TGT</c:v>
                </c:pt>
                <c:pt idx="61">
                  <c:v>CCC</c:v>
                </c:pt>
                <c:pt idx="62">
                  <c:v>CCT</c:v>
                </c:pt>
                <c:pt idx="63">
                  <c:v>CCA</c:v>
                </c:pt>
              </c:strCache>
            </c:strRef>
          </c:cat>
          <c:val>
            <c:numRef>
              <c:f>'Freq HI DSP SSP'!$AT$4:$AT$67</c:f>
              <c:numCache>
                <c:formatCode>General</c:formatCode>
                <c:ptCount val="64"/>
                <c:pt idx="0">
                  <c:v>9.0304718787543811E-4</c:v>
                </c:pt>
                <c:pt idx="1">
                  <c:v>1.0485704134020827E-3</c:v>
                </c:pt>
                <c:pt idx="2">
                  <c:v>1.0120345977483675E-3</c:v>
                </c:pt>
                <c:pt idx="3">
                  <c:v>2.8348756847951517E-3</c:v>
                </c:pt>
                <c:pt idx="4">
                  <c:v>3.5240884890279599E-3</c:v>
                </c:pt>
                <c:pt idx="5">
                  <c:v>3.7566126450318603E-3</c:v>
                </c:pt>
                <c:pt idx="6">
                  <c:v>5.1562202610377916E-3</c:v>
                </c:pt>
                <c:pt idx="7">
                  <c:v>4.2891224316772185E-3</c:v>
                </c:pt>
                <c:pt idx="8">
                  <c:v>5.4246936105468851E-3</c:v>
                </c:pt>
                <c:pt idx="9">
                  <c:v>7.7829080073813818E-3</c:v>
                </c:pt>
                <c:pt idx="10">
                  <c:v>7.1858422772297882E-3</c:v>
                </c:pt>
                <c:pt idx="11">
                  <c:v>4.7986506053093016E-3</c:v>
                </c:pt>
                <c:pt idx="12">
                  <c:v>7.4127512241840155E-3</c:v>
                </c:pt>
                <c:pt idx="13">
                  <c:v>7.3879532988114036E-3</c:v>
                </c:pt>
                <c:pt idx="14">
                  <c:v>8.4615341165334076E-3</c:v>
                </c:pt>
                <c:pt idx="15">
                  <c:v>1.0161000309788832E-2</c:v>
                </c:pt>
                <c:pt idx="16">
                  <c:v>9.4324769602013685E-3</c:v>
                </c:pt>
                <c:pt idx="17">
                  <c:v>1.1685708914029976E-2</c:v>
                </c:pt>
                <c:pt idx="18">
                  <c:v>9.4891534398718544E-3</c:v>
                </c:pt>
                <c:pt idx="19">
                  <c:v>8.9317547045126913E-3</c:v>
                </c:pt>
                <c:pt idx="20">
                  <c:v>1.16694050998053E-2</c:v>
                </c:pt>
                <c:pt idx="21">
                  <c:v>1.058163388348936E-2</c:v>
                </c:pt>
                <c:pt idx="22">
                  <c:v>1.1904624226813513E-2</c:v>
                </c:pt>
                <c:pt idx="23">
                  <c:v>1.0268924522822425E-2</c:v>
                </c:pt>
                <c:pt idx="24">
                  <c:v>1.0644366972000146E-2</c:v>
                </c:pt>
                <c:pt idx="25">
                  <c:v>1.0747154951302287E-2</c:v>
                </c:pt>
                <c:pt idx="26">
                  <c:v>1.2158206553537729E-2</c:v>
                </c:pt>
                <c:pt idx="27">
                  <c:v>1.2275336630291652E-2</c:v>
                </c:pt>
                <c:pt idx="28">
                  <c:v>1.4188258918778366E-2</c:v>
                </c:pt>
                <c:pt idx="29">
                  <c:v>1.4179817497958488E-2</c:v>
                </c:pt>
                <c:pt idx="30">
                  <c:v>1.1917927904461167E-2</c:v>
                </c:pt>
                <c:pt idx="31">
                  <c:v>1.5290805908680153E-2</c:v>
                </c:pt>
                <c:pt idx="32">
                  <c:v>1.7027192042350672E-2</c:v>
                </c:pt>
                <c:pt idx="33">
                  <c:v>1.3072303455214171E-2</c:v>
                </c:pt>
                <c:pt idx="34">
                  <c:v>1.3240830468897567E-2</c:v>
                </c:pt>
                <c:pt idx="35">
                  <c:v>1.4700800506570218E-2</c:v>
                </c:pt>
                <c:pt idx="36">
                  <c:v>1.5990154401810786E-2</c:v>
                </c:pt>
                <c:pt idx="37">
                  <c:v>1.8949088700234172E-2</c:v>
                </c:pt>
                <c:pt idx="38">
                  <c:v>1.7813960050888863E-2</c:v>
                </c:pt>
                <c:pt idx="39">
                  <c:v>1.5418925022039998E-2</c:v>
                </c:pt>
                <c:pt idx="40">
                  <c:v>1.9203247587010055E-2</c:v>
                </c:pt>
                <c:pt idx="41">
                  <c:v>2.0233714428894736E-2</c:v>
                </c:pt>
                <c:pt idx="42">
                  <c:v>1.7198528024006607E-2</c:v>
                </c:pt>
                <c:pt idx="43">
                  <c:v>2.1804099265060158E-2</c:v>
                </c:pt>
                <c:pt idx="44">
                  <c:v>1.6405277801483497E-2</c:v>
                </c:pt>
                <c:pt idx="45">
                  <c:v>2.1344918874365786E-2</c:v>
                </c:pt>
                <c:pt idx="46">
                  <c:v>1.670202605040156E-2</c:v>
                </c:pt>
                <c:pt idx="47">
                  <c:v>1.6963476380239619E-2</c:v>
                </c:pt>
                <c:pt idx="48">
                  <c:v>1.9859374345935536E-2</c:v>
                </c:pt>
                <c:pt idx="49">
                  <c:v>1.736976195705723E-2</c:v>
                </c:pt>
                <c:pt idx="50">
                  <c:v>2.2015959002649483E-2</c:v>
                </c:pt>
                <c:pt idx="51">
                  <c:v>2.2231973187703168E-2</c:v>
                </c:pt>
                <c:pt idx="52">
                  <c:v>2.5571709986402246E-2</c:v>
                </c:pt>
                <c:pt idx="53">
                  <c:v>2.2704572922662664E-2</c:v>
                </c:pt>
                <c:pt idx="54">
                  <c:v>2.4783032240433874E-2</c:v>
                </c:pt>
                <c:pt idx="55">
                  <c:v>2.9404345764801731E-2</c:v>
                </c:pt>
                <c:pt idx="56">
                  <c:v>2.7468776795560243E-2</c:v>
                </c:pt>
                <c:pt idx="57">
                  <c:v>3.1823078744523461E-2</c:v>
                </c:pt>
                <c:pt idx="58">
                  <c:v>3.2540671914176519E-2</c:v>
                </c:pt>
                <c:pt idx="59">
                  <c:v>3.1760475087081672E-2</c:v>
                </c:pt>
                <c:pt idx="60">
                  <c:v>3.0574066304397234E-2</c:v>
                </c:pt>
                <c:pt idx="61">
                  <c:v>3.5971846897515293E-2</c:v>
                </c:pt>
                <c:pt idx="62">
                  <c:v>4.0533325968673477E-2</c:v>
                </c:pt>
                <c:pt idx="63">
                  <c:v>4.281302357202033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B4-40D3-8EF8-562B3369A7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44496784"/>
        <c:axId val="1143098128"/>
      </c:barChart>
      <c:catAx>
        <c:axId val="1144496784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cross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3098128"/>
        <c:crosses val="autoZero"/>
        <c:auto val="1"/>
        <c:lblAlgn val="ctr"/>
        <c:lblOffset val="100"/>
        <c:noMultiLvlLbl val="0"/>
      </c:catAx>
      <c:valAx>
        <c:axId val="1143098128"/>
        <c:scaling>
          <c:orientation val="minMax"/>
          <c:max val="5.5000000000000007E-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4449678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350715974483641"/>
          <c:y val="1.9303608746950727E-2"/>
          <c:w val="0.32693148211154444"/>
          <c:h val="2.20154048458873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EF9C7D-1A3B-4B6F-ACD6-E98D959A29D5}" type="datetimeFigureOut">
              <a:rPr lang="fr-FR" smtClean="0"/>
              <a:t>17/09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8660EF-5093-4EBE-A79B-31E6E61EE4E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8796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940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578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98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7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75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387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081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467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973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271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747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5BA09-05D3-4894-82C0-2A0F260B1FE8}" type="datetimeFigureOut">
              <a:rPr lang="en-US" smtClean="0"/>
              <a:t>9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69048-19B1-47D2-9CA5-EBF9E281D9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996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B0B3790-8DE2-4140-8340-F863D85BB561}"/>
              </a:ext>
            </a:extLst>
          </p:cNvPr>
          <p:cNvSpPr txBox="1"/>
          <p:nvPr/>
        </p:nvSpPr>
        <p:spPr>
          <a:xfrm>
            <a:off x="1101007" y="2568942"/>
            <a:ext cx="439501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dirty="0" err="1"/>
              <a:t>Supplementary</a:t>
            </a:r>
            <a:r>
              <a:rPr lang="fr-FR" sz="2400" dirty="0"/>
              <a:t> figures and tables for </a:t>
            </a:r>
            <a:r>
              <a:rPr lang="fr-FR" sz="2400" dirty="0" err="1"/>
              <a:t>manuscript</a:t>
            </a:r>
            <a:r>
              <a:rPr lang="fr-FR" sz="2400" dirty="0"/>
              <a:t> </a:t>
            </a:r>
            <a:r>
              <a:rPr lang="en-US" sz="2400" dirty="0"/>
              <a:t>“Single- and double-strand circulating DNA </a:t>
            </a:r>
            <a:r>
              <a:rPr lang="en-US" sz="2400" dirty="0" err="1"/>
              <a:t>fragmentomics</a:t>
            </a:r>
            <a:r>
              <a:rPr lang="en-US" sz="2400" dirty="0"/>
              <a:t> for enhanced cancer detection performance”</a:t>
            </a:r>
          </a:p>
        </p:txBody>
      </p:sp>
    </p:spTree>
    <p:extLst>
      <p:ext uri="{BB962C8B-B14F-4D97-AF65-F5344CB8AC3E}">
        <p14:creationId xmlns:p14="http://schemas.microsoft.com/office/powerpoint/2010/main" val="600436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46425040-5017-48C6-AF08-37507F0F893E}"/>
              </a:ext>
            </a:extLst>
          </p:cNvPr>
          <p:cNvSpPr/>
          <p:nvPr/>
        </p:nvSpPr>
        <p:spPr>
          <a:xfrm>
            <a:off x="0" y="13915"/>
            <a:ext cx="67691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b="1" dirty="0"/>
              <a:t>Figure S1. Relative </a:t>
            </a:r>
            <a:r>
              <a:rPr lang="fr-FR" sz="1000" b="1" dirty="0" err="1"/>
              <a:t>frequencies</a:t>
            </a:r>
            <a:r>
              <a:rPr lang="fr-FR" sz="1000" b="1" dirty="0"/>
              <a:t> of 3 </a:t>
            </a:r>
            <a:r>
              <a:rPr lang="fr-FR" sz="1000" b="1" dirty="0" err="1"/>
              <a:t>bp</a:t>
            </a:r>
            <a:r>
              <a:rPr lang="fr-FR" sz="1000" b="1" dirty="0"/>
              <a:t> end motifs.</a:t>
            </a:r>
            <a:r>
              <a:rPr lang="fr-FR" sz="1000" dirty="0"/>
              <a:t> </a:t>
            </a:r>
            <a:r>
              <a:rPr lang="en-US" sz="1000" b="1" dirty="0"/>
              <a:t>(A)</a:t>
            </a:r>
            <a:r>
              <a:rPr lang="en-US" sz="1000" dirty="0"/>
              <a:t> D</a:t>
            </a:r>
            <a:r>
              <a:rPr lang="fr-FR" sz="1000" dirty="0" err="1"/>
              <a:t>ouble-strand</a:t>
            </a:r>
            <a:r>
              <a:rPr lang="fr-FR" sz="1000" dirty="0"/>
              <a:t> </a:t>
            </a:r>
            <a:r>
              <a:rPr lang="fr-FR" sz="1000" dirty="0" err="1"/>
              <a:t>library</a:t>
            </a:r>
            <a:r>
              <a:rPr lang="fr-FR" sz="1000" dirty="0"/>
              <a:t> </a:t>
            </a:r>
            <a:r>
              <a:rPr lang="fr-FR" sz="1000" dirty="0" err="1"/>
              <a:t>preparation</a:t>
            </a:r>
            <a:r>
              <a:rPr lang="fr-FR" sz="1000" dirty="0"/>
              <a:t> (DSP) </a:t>
            </a:r>
            <a:r>
              <a:rPr lang="fr-FR" sz="1000" dirty="0" err="1"/>
              <a:t>comparing</a:t>
            </a:r>
            <a:r>
              <a:rPr lang="fr-FR" sz="1000" dirty="0"/>
              <a:t> 3’ </a:t>
            </a:r>
            <a:r>
              <a:rPr lang="en-US" sz="1000" dirty="0"/>
              <a:t>and 5’ extremities in healthy individuals (n=37). </a:t>
            </a:r>
            <a:r>
              <a:rPr lang="en-US" sz="1000" b="1" dirty="0"/>
              <a:t>(B)</a:t>
            </a:r>
            <a:r>
              <a:rPr lang="en-US" sz="1000" dirty="0"/>
              <a:t> Comparing healthy individuals and patients with cancer (BC, n=50; NSCLC, n=54; mCRC, n=15) using 5’ end motifs</a:t>
            </a:r>
            <a:r>
              <a:rPr lang="fr-FR" sz="1000" dirty="0"/>
              <a:t>.</a:t>
            </a:r>
            <a:endParaRPr lang="en-US" sz="100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9D1CAF9-E610-4038-8475-2E5E579736A0}"/>
              </a:ext>
            </a:extLst>
          </p:cNvPr>
          <p:cNvSpPr txBox="1"/>
          <p:nvPr/>
        </p:nvSpPr>
        <p:spPr>
          <a:xfrm>
            <a:off x="20558" y="567913"/>
            <a:ext cx="3368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5CB2F7C-E211-48F5-9E6B-2489475EF652}"/>
              </a:ext>
            </a:extLst>
          </p:cNvPr>
          <p:cNvSpPr txBox="1"/>
          <p:nvPr/>
        </p:nvSpPr>
        <p:spPr>
          <a:xfrm>
            <a:off x="3429000" y="506213"/>
            <a:ext cx="3368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/>
              <a:t>B</a:t>
            </a:r>
          </a:p>
        </p:txBody>
      </p:sp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2EDD3668-566B-493F-9EE3-E9A1664EB0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1757231"/>
              </p:ext>
            </p:extLst>
          </p:nvPr>
        </p:nvGraphicFramePr>
        <p:xfrm>
          <a:off x="189000" y="706268"/>
          <a:ext cx="3240000" cy="916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phique 9">
            <a:extLst>
              <a:ext uri="{FF2B5EF4-FFF2-40B4-BE49-F238E27FC236}">
                <a16:creationId xmlns:a16="http://schemas.microsoft.com/office/drawing/2014/main" id="{82031889-F497-42B4-8417-EDF7238CA3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771416"/>
              </p:ext>
            </p:extLst>
          </p:nvPr>
        </p:nvGraphicFramePr>
        <p:xfrm>
          <a:off x="3332998" y="706268"/>
          <a:ext cx="3240000" cy="916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042788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1F04E15A-D6F8-47CB-867C-939A3247DB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3574556"/>
              </p:ext>
            </p:extLst>
          </p:nvPr>
        </p:nvGraphicFramePr>
        <p:xfrm>
          <a:off x="1999239" y="292685"/>
          <a:ext cx="2520000" cy="9024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6AA89F12-2543-4046-A0A8-E45695D798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0708953"/>
              </p:ext>
            </p:extLst>
          </p:nvPr>
        </p:nvGraphicFramePr>
        <p:xfrm>
          <a:off x="4326809" y="292685"/>
          <a:ext cx="2520000" cy="9024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Graphique 9">
            <a:extLst>
              <a:ext uri="{FF2B5EF4-FFF2-40B4-BE49-F238E27FC236}">
                <a16:creationId xmlns:a16="http://schemas.microsoft.com/office/drawing/2014/main" id="{E4628E2F-35E4-4EC2-AE64-26859ECBF6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5539076"/>
              </p:ext>
            </p:extLst>
          </p:nvPr>
        </p:nvGraphicFramePr>
        <p:xfrm>
          <a:off x="0" y="319318"/>
          <a:ext cx="2168434" cy="9024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A94CAE28-DB49-416A-A24E-29CBE645DB88}"/>
              </a:ext>
            </a:extLst>
          </p:cNvPr>
          <p:cNvSpPr/>
          <p:nvPr/>
        </p:nvSpPr>
        <p:spPr>
          <a:xfrm>
            <a:off x="142738" y="61995"/>
            <a:ext cx="6572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b="1" dirty="0"/>
              <a:t>Figure S2. Relative </a:t>
            </a:r>
            <a:r>
              <a:rPr lang="fr-FR" sz="1000" b="1" dirty="0" err="1"/>
              <a:t>frequencies</a:t>
            </a:r>
            <a:r>
              <a:rPr lang="fr-FR" sz="1000" b="1" dirty="0"/>
              <a:t> of 3 </a:t>
            </a:r>
            <a:r>
              <a:rPr lang="fr-FR" sz="1000" b="1" dirty="0" err="1"/>
              <a:t>bp</a:t>
            </a:r>
            <a:r>
              <a:rPr lang="fr-FR" sz="1000" b="1" dirty="0"/>
              <a:t> end motifs in </a:t>
            </a:r>
            <a:r>
              <a:rPr lang="fr-FR" sz="1000" b="1" dirty="0" err="1"/>
              <a:t>our</a:t>
            </a:r>
            <a:r>
              <a:rPr lang="fr-FR" sz="1000" b="1" dirty="0"/>
              <a:t> </a:t>
            </a:r>
            <a:r>
              <a:rPr lang="fr-FR" sz="1000" b="1" dirty="0" err="1"/>
              <a:t>cohorts</a:t>
            </a:r>
            <a:r>
              <a:rPr lang="fr-FR" sz="1000" b="1" dirty="0"/>
              <a:t> of patents </a:t>
            </a:r>
            <a:r>
              <a:rPr lang="fr-FR" sz="1000" b="1" dirty="0" err="1"/>
              <a:t>with</a:t>
            </a:r>
            <a:r>
              <a:rPr lang="fr-FR" sz="1000" b="1" dirty="0"/>
              <a:t> BC, NSCLC and </a:t>
            </a:r>
            <a:r>
              <a:rPr lang="fr-FR" sz="1000" b="1" dirty="0" err="1"/>
              <a:t>mCRC</a:t>
            </a:r>
            <a:r>
              <a:rPr lang="fr-FR" sz="1000" b="1" dirty="0"/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1805021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8F01D36A-1333-4C02-BFBD-1C14AD2225C7}"/>
              </a:ext>
            </a:extLst>
          </p:cNvPr>
          <p:cNvSpPr/>
          <p:nvPr/>
        </p:nvSpPr>
        <p:spPr>
          <a:xfrm>
            <a:off x="468616" y="59215"/>
            <a:ext cx="6572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b="1" dirty="0"/>
              <a:t>Figure S3. Relative </a:t>
            </a:r>
            <a:r>
              <a:rPr lang="fr-FR" sz="1000" b="1" dirty="0" err="1"/>
              <a:t>frequencies</a:t>
            </a:r>
            <a:r>
              <a:rPr lang="fr-FR" sz="1000" b="1" dirty="0"/>
              <a:t> of 3 </a:t>
            </a:r>
            <a:r>
              <a:rPr lang="fr-FR" sz="1000" b="1" dirty="0" err="1"/>
              <a:t>bp</a:t>
            </a:r>
            <a:r>
              <a:rPr lang="fr-FR" sz="1000" b="1" dirty="0"/>
              <a:t> end motifs in </a:t>
            </a:r>
            <a:r>
              <a:rPr lang="fr-FR" sz="1000" b="1" dirty="0" err="1"/>
              <a:t>our</a:t>
            </a:r>
            <a:r>
              <a:rPr lang="fr-FR" sz="1000" b="1" dirty="0"/>
              <a:t> </a:t>
            </a:r>
            <a:r>
              <a:rPr lang="fr-FR" sz="1000" b="1" dirty="0" err="1"/>
              <a:t>cohort</a:t>
            </a:r>
            <a:r>
              <a:rPr lang="fr-FR" sz="1000" b="1" dirty="0"/>
              <a:t> of HI </a:t>
            </a:r>
            <a:r>
              <a:rPr lang="fr-FR" sz="1000" b="1" dirty="0" err="1"/>
              <a:t>using</a:t>
            </a:r>
            <a:r>
              <a:rPr lang="fr-FR" sz="1000" b="1" dirty="0"/>
              <a:t> DSP and SSP.</a:t>
            </a:r>
            <a:endParaRPr lang="en-US" sz="10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F189727-E899-4B89-A041-9AB389F11010}"/>
              </a:ext>
            </a:extLst>
          </p:cNvPr>
          <p:cNvSpPr txBox="1"/>
          <p:nvPr/>
        </p:nvSpPr>
        <p:spPr>
          <a:xfrm>
            <a:off x="3272925" y="270635"/>
            <a:ext cx="279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dirty="0"/>
              <a:t>B</a:t>
            </a:r>
            <a:endParaRPr lang="fr-FR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8C44303-2D67-4456-90B8-D36C55C09072}"/>
              </a:ext>
            </a:extLst>
          </p:cNvPr>
          <p:cNvSpPr txBox="1"/>
          <p:nvPr/>
        </p:nvSpPr>
        <p:spPr>
          <a:xfrm>
            <a:off x="6683" y="270635"/>
            <a:ext cx="279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dirty="0"/>
              <a:t>A</a:t>
            </a:r>
            <a:endParaRPr lang="fr-FR" dirty="0"/>
          </a:p>
        </p:txBody>
      </p:sp>
      <p:graphicFrame>
        <p:nvGraphicFramePr>
          <p:cNvPr id="13" name="Graphique 12">
            <a:extLst>
              <a:ext uri="{FF2B5EF4-FFF2-40B4-BE49-F238E27FC236}">
                <a16:creationId xmlns:a16="http://schemas.microsoft.com/office/drawing/2014/main" id="{8BA9F832-B304-4358-B9C4-04A8A921A15D}"/>
              </a:ext>
            </a:extLst>
          </p:cNvPr>
          <p:cNvGraphicFramePr>
            <a:graphicFrameLocks/>
          </p:cNvGraphicFramePr>
          <p:nvPr/>
        </p:nvGraphicFramePr>
        <p:xfrm>
          <a:off x="189000" y="305436"/>
          <a:ext cx="3240000" cy="916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id="{A8448342-A925-4725-9CBC-A0399E19E57B}"/>
              </a:ext>
            </a:extLst>
          </p:cNvPr>
          <p:cNvGraphicFramePr>
            <a:graphicFrameLocks/>
          </p:cNvGraphicFramePr>
          <p:nvPr/>
        </p:nvGraphicFramePr>
        <p:xfrm>
          <a:off x="3512309" y="305436"/>
          <a:ext cx="3048710" cy="916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933119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90AC783B-71D7-48A6-B0C3-398D6FE62345}"/>
              </a:ext>
            </a:extLst>
          </p:cNvPr>
          <p:cNvGraphicFramePr>
            <a:graphicFrameLocks/>
          </p:cNvGraphicFramePr>
          <p:nvPr/>
        </p:nvGraphicFramePr>
        <p:xfrm>
          <a:off x="3429000" y="284676"/>
          <a:ext cx="3048712" cy="9336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EB6A4E98-9D67-442F-BD64-AAFB49DF322D}"/>
              </a:ext>
            </a:extLst>
          </p:cNvPr>
          <p:cNvGraphicFramePr>
            <a:graphicFrameLocks/>
          </p:cNvGraphicFramePr>
          <p:nvPr/>
        </p:nvGraphicFramePr>
        <p:xfrm>
          <a:off x="380288" y="284676"/>
          <a:ext cx="3048712" cy="9336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46E2E191-535D-4704-AC91-F7DB2E36AE1C}"/>
              </a:ext>
            </a:extLst>
          </p:cNvPr>
          <p:cNvSpPr/>
          <p:nvPr/>
        </p:nvSpPr>
        <p:spPr>
          <a:xfrm>
            <a:off x="211009" y="38455"/>
            <a:ext cx="6572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b="1" dirty="0"/>
              <a:t>Figure S4. Relative </a:t>
            </a:r>
            <a:r>
              <a:rPr lang="fr-FR" sz="1000" b="1" dirty="0" err="1"/>
              <a:t>frequencies</a:t>
            </a:r>
            <a:r>
              <a:rPr lang="fr-FR" sz="1000" b="1" dirty="0"/>
              <a:t> of 3 </a:t>
            </a:r>
            <a:r>
              <a:rPr lang="fr-FR" sz="1000" b="1" dirty="0" err="1"/>
              <a:t>bp</a:t>
            </a:r>
            <a:r>
              <a:rPr lang="fr-FR" sz="1000" b="1" dirty="0"/>
              <a:t> end motifs in </a:t>
            </a:r>
            <a:r>
              <a:rPr lang="fr-FR" sz="1000" b="1" dirty="0" err="1"/>
              <a:t>our</a:t>
            </a:r>
            <a:r>
              <a:rPr lang="fr-FR" sz="1000" b="1" dirty="0"/>
              <a:t> </a:t>
            </a:r>
            <a:r>
              <a:rPr lang="fr-FR" sz="1000" b="1" dirty="0" err="1"/>
              <a:t>cohort</a:t>
            </a:r>
            <a:r>
              <a:rPr lang="fr-FR" sz="1000" b="1" dirty="0"/>
              <a:t> of patients </a:t>
            </a:r>
            <a:r>
              <a:rPr lang="fr-FR" sz="1000" b="1" dirty="0" err="1"/>
              <a:t>with</a:t>
            </a:r>
            <a:r>
              <a:rPr lang="fr-FR" sz="1000" b="1" dirty="0"/>
              <a:t> </a:t>
            </a:r>
            <a:r>
              <a:rPr lang="fr-FR" sz="1000" b="1" dirty="0" err="1"/>
              <a:t>mCRC</a:t>
            </a:r>
            <a:r>
              <a:rPr lang="fr-FR" sz="1000" b="1" dirty="0"/>
              <a:t> </a:t>
            </a:r>
            <a:r>
              <a:rPr lang="fr-FR" sz="1000" b="1" dirty="0" err="1"/>
              <a:t>using</a:t>
            </a:r>
            <a:r>
              <a:rPr lang="fr-FR" sz="1000" b="1" dirty="0"/>
              <a:t> DSP and SSP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8488903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F0DA39C4-0C97-4105-8938-58853EF419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652721"/>
              </p:ext>
            </p:extLst>
          </p:nvPr>
        </p:nvGraphicFramePr>
        <p:xfrm>
          <a:off x="381000" y="1211792"/>
          <a:ext cx="5689600" cy="31305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44320">
                  <a:extLst>
                    <a:ext uri="{9D8B030D-6E8A-4147-A177-3AD203B41FA5}">
                      <a16:colId xmlns:a16="http://schemas.microsoft.com/office/drawing/2014/main" val="1745697052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val="4236625558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val="3734780624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val="201984365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val="1073513103"/>
                    </a:ext>
                  </a:extLst>
                </a:gridCol>
              </a:tblGrid>
              <a:tr h="3683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 err="1">
                          <a:effectLst/>
                        </a:rPr>
                        <a:t>Characteristic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>
                          <a:effectLst/>
                        </a:rPr>
                        <a:t>HI (n=37)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>
                          <a:effectLst/>
                        </a:rPr>
                        <a:t>BC (n=50)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>
                          <a:effectLst/>
                        </a:rPr>
                        <a:t>NSCLC (n=56)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 err="1">
                          <a:effectLst/>
                        </a:rPr>
                        <a:t>mCRC</a:t>
                      </a:r>
                      <a:r>
                        <a:rPr lang="fr-FR" sz="1400" b="1" u="none" strike="noStrike" dirty="0">
                          <a:effectLst/>
                        </a:rPr>
                        <a:t> (n=15)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27669960"/>
                  </a:ext>
                </a:extLst>
              </a:tr>
              <a:tr h="3683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Age (</a:t>
                      </a:r>
                      <a:r>
                        <a:rPr lang="fr-FR" sz="1100" b="1" u="none" strike="noStrike" dirty="0" err="1">
                          <a:effectLst/>
                        </a:rPr>
                        <a:t>mean</a:t>
                      </a:r>
                      <a:r>
                        <a:rPr lang="fr-FR" sz="1100" b="1" u="none" strike="noStrike" dirty="0">
                          <a:effectLst/>
                        </a:rPr>
                        <a:t> ± SD)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45.6 ± 14.7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 dirty="0">
                          <a:effectLst/>
                        </a:rPr>
                        <a:t>59.4 ± 15.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 dirty="0">
                          <a:effectLst/>
                        </a:rPr>
                        <a:t>65.7 ± 9.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4 ± 10.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9602792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Age Range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21-63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29-94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42-83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-6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8438752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 err="1">
                          <a:effectLst/>
                        </a:rPr>
                        <a:t>Gender</a:t>
                      </a:r>
                      <a:r>
                        <a:rPr lang="fr-FR" sz="1100" b="1" u="none" strike="noStrike" dirty="0">
                          <a:effectLst/>
                        </a:rPr>
                        <a:t> (n, %)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7981745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Male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24 (65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33 (59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53%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05705046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</a:t>
                      </a:r>
                      <a:r>
                        <a:rPr lang="fr-FR" sz="1100" b="1" u="none" strike="noStrike" dirty="0" err="1">
                          <a:effectLst/>
                        </a:rPr>
                        <a:t>Female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13 (35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50 (10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23 (41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47%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63916123"/>
                  </a:ext>
                </a:extLst>
              </a:tr>
              <a:tr h="3683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Cancer Stage (n, %)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228806672"/>
                  </a:ext>
                </a:extLst>
              </a:tr>
              <a:tr h="3683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Stage 0 (In situ)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97944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Stage I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36 (64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13678596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Stage II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6350" marR="6350" marT="6350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50 (10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13 (23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6867802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Stage III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6350" marR="6350" marT="6350" marB="0" anchor="ctr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7 (13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31801003"/>
                  </a:ext>
                </a:extLst>
              </a:tr>
              <a:tr h="3683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1" u="none" strike="noStrike" dirty="0">
                          <a:effectLst/>
                        </a:rPr>
                        <a:t>- Stage IV (</a:t>
                      </a:r>
                      <a:r>
                        <a:rPr lang="fr-FR" sz="1100" b="1" u="none" strike="noStrike" dirty="0" err="1">
                          <a:effectLst/>
                        </a:rPr>
                        <a:t>Metastatic</a:t>
                      </a:r>
                      <a:r>
                        <a:rPr lang="fr-FR" sz="1100" b="1" u="none" strike="noStrike" dirty="0">
                          <a:effectLst/>
                        </a:rPr>
                        <a:t>)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>
                          <a:effectLst/>
                        </a:rPr>
                        <a:t>0 (0%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u="none" strike="noStrike" dirty="0">
                          <a:effectLst/>
                        </a:rPr>
                        <a:t>15 (100%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968822157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E0F5076F-1880-4C87-B2B3-7A2384840C36}"/>
              </a:ext>
            </a:extLst>
          </p:cNvPr>
          <p:cNvSpPr txBox="1"/>
          <p:nvPr/>
        </p:nvSpPr>
        <p:spPr>
          <a:xfrm>
            <a:off x="164820" y="52676"/>
            <a:ext cx="31856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/>
              <a:t>Table S1. </a:t>
            </a:r>
            <a:r>
              <a:rPr lang="fr-FR" sz="1600" dirty="0" err="1"/>
              <a:t>Characteristics</a:t>
            </a:r>
            <a:r>
              <a:rPr lang="fr-FR" sz="1600" dirty="0"/>
              <a:t> of patients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24797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A1F02A3B-BB9E-4A58-85CB-0CBF37BF48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0" y="1132426"/>
            <a:ext cx="1734819" cy="8674100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650AFEC6-092A-4C75-B132-7DABFCD3BC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800" y="1132426"/>
            <a:ext cx="1734819" cy="86741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F11A09DB-16CB-4A0F-8BF3-4C59B51A7A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6090" y="1145126"/>
            <a:ext cx="1734819" cy="86741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25D62A3F-830A-4E66-BDF2-57712462003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2700" y="1145126"/>
            <a:ext cx="1734819" cy="867410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F6F0339D-9291-4EAD-A8FD-3B48E94D58B7}"/>
              </a:ext>
            </a:extLst>
          </p:cNvPr>
          <p:cNvSpPr txBox="1"/>
          <p:nvPr/>
        </p:nvSpPr>
        <p:spPr>
          <a:xfrm flipH="1">
            <a:off x="25400" y="498795"/>
            <a:ext cx="6740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Importance of the 3 </a:t>
            </a:r>
            <a:r>
              <a:rPr lang="fr-FR" dirty="0" err="1"/>
              <a:t>bp</a:t>
            </a:r>
            <a:r>
              <a:rPr lang="fr-FR" dirty="0"/>
              <a:t> end motifs for cancer vs </a:t>
            </a:r>
            <a:r>
              <a:rPr lang="fr-FR" dirty="0" err="1"/>
              <a:t>healthy</a:t>
            </a:r>
            <a:r>
              <a:rPr lang="fr-FR" dirty="0"/>
              <a:t> classification </a:t>
            </a:r>
            <a:r>
              <a:rPr lang="fr-FR" dirty="0" err="1"/>
              <a:t>using</a:t>
            </a:r>
            <a:r>
              <a:rPr lang="fr-FR" dirty="0"/>
              <a:t> SHAP </a:t>
            </a:r>
            <a:r>
              <a:rPr lang="fr-FR" dirty="0" err="1"/>
              <a:t>from</a:t>
            </a:r>
            <a:r>
              <a:rPr lang="fr-FR" dirty="0"/>
              <a:t> </a:t>
            </a:r>
            <a:r>
              <a:rPr lang="fr-FR" dirty="0" err="1"/>
              <a:t>Random</a:t>
            </a:r>
            <a:r>
              <a:rPr lang="fr-FR" dirty="0"/>
              <a:t> Fores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016FC7C-4DA1-4BD2-B934-7A3516F5A8F0}"/>
              </a:ext>
            </a:extLst>
          </p:cNvPr>
          <p:cNvSpPr txBox="1"/>
          <p:nvPr/>
        </p:nvSpPr>
        <p:spPr>
          <a:xfrm>
            <a:off x="25400" y="146803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/>
              <a:t>Figure S5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8915735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58</TotalTime>
  <Words>417</Words>
  <Application>Microsoft Macintosh PowerPoint</Application>
  <PresentationFormat>Format A4 (210 x 297 mm)</PresentationFormat>
  <Paragraphs>74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katerina.pisareva@ircm.local</dc:creator>
  <cp:lastModifiedBy>Microsoft Office User</cp:lastModifiedBy>
  <cp:revision>1808</cp:revision>
  <cp:lastPrinted>2025-03-20T10:51:39Z</cp:lastPrinted>
  <dcterms:created xsi:type="dcterms:W3CDTF">2025-02-14T08:54:08Z</dcterms:created>
  <dcterms:modified xsi:type="dcterms:W3CDTF">2025-09-17T20:56:30Z</dcterms:modified>
</cp:coreProperties>
</file>